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7" r:id="rId2"/>
    <p:sldId id="261" r:id="rId3"/>
    <p:sldId id="265" r:id="rId4"/>
    <p:sldId id="257" r:id="rId5"/>
    <p:sldId id="262" r:id="rId6"/>
    <p:sldId id="271" r:id="rId7"/>
    <p:sldId id="258" r:id="rId8"/>
    <p:sldId id="27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114" y="1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FB4CE9-AC2A-439E-9CAD-2630FD664F98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267ABF-0190-4A18-BC68-9517B6F9CC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318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267ABF-0190-4A18-BC68-9517B6F9CCE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4364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267ABF-0190-4A18-BC68-9517B6F9CCE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7635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9CB1B9-D671-4978-918E-EFEF8100C0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110157-E72E-4342-9690-01C5CBD57A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11DD7E-2195-409F-9D26-281C87C9F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528BF9-45AB-47AE-8048-5CD02D25A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2E8E57-6963-4FB1-815D-3D0A80A33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817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A3DEC-0F73-4E87-A84B-5D511DE01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49FD51-FBBE-488D-AD73-2E08E27F9F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B4EB39-D5D3-431F-A42D-6CC57C2D2E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9D7617-3A63-4896-9CB7-506AC927D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1A902F-4FE5-4AD6-BB19-3F8AD27FA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651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99C725-B71C-497B-A4B7-4A1587E8B9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5A17B9-7E50-44A5-B096-96D2FE408E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F690BC-8F49-4D69-BB49-5B137AD4D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203D9-782F-4D2E-AA61-08B37422C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3B417-B3FE-419E-9679-E204F7101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119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F49FED-BF17-448D-9E56-29FF83936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395F1F-3DEE-44F8-8985-0FAE88921A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AE2B18-BA24-41BF-961B-AF0C5D5D2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5302BF-BB1D-4AF6-810B-FB851C37F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753F00-41B4-47B2-9445-E4A3F80F5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718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DD4E48-3115-438D-9818-B4D779DF37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B24F34-B562-4480-B49A-C6225F314A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32D6A-C750-4C76-BD7F-E617DA514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17BCA9-C1E7-4CE5-BF49-479106F04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F92C06-E20A-4716-A3EA-3B4CF1C89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024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3A9C6-3C37-49D9-816F-031EC936F3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A73627-DF12-4FE8-BCF1-C7FB238F12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FA3601-06A0-4B35-8A22-2E39646B2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F9B6F1-D40C-4EBF-A8F6-A38ABE0F4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683E2E-93BE-440A-A08F-5D18734D9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78A749-6AE8-4970-AF48-6EBEAFD30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26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5FA5A-16C3-4400-ADB6-154388D124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75C26C-2B15-428B-ABE4-C31D1025E2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0EAC00-6497-43EE-8474-535B58F749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4196B7-9A9B-4AAC-B766-D21EED2A00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6F51DB-88A1-4720-AA5D-013EA0910B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160EC2-5CA9-48E2-830A-263A6D5F1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9AB5AF-1414-4549-A307-74C6F5B10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2CDBB2-E86F-4B0F-AE64-53256877F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697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32193C-FA58-4583-AF5F-A203FA7480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A00465F-1A18-4888-811B-424430307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A915F1-9AF5-49CB-9D27-349C9FD92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F766A9E-D2F0-458E-B5ED-25E62C498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019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C2F64C-059D-4A15-AC59-DCEBA7318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CA4309-A43B-40BD-AD5F-D99ADF8D5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D7AF5E-5F6C-47BC-B6FD-E68C82F9A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245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273E2C-80D1-49F7-B852-7F5902D59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F31F12-AA63-465F-8638-52E044834C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39DD3C-8D67-48D6-AD65-135D00D581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0752A8-99AF-4D35-8473-A5BA33854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7EEEBA-514C-43AF-AFE6-758103625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D13144-1A99-4A53-89F2-BFB013D10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748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4C4625-EAA6-43F7-B2EE-75F2E204BF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EE9D43-6A5F-4E15-A0B0-2BE591DC0D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C083F5-58A9-4DF5-88CB-2AE7817265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899032-1F3D-4697-85E7-3A9A00856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56C897-E394-492C-B95B-40BED8F89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B7D0C4-5CEF-4FBB-8A3E-7EF2B6E69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759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65768D-5A56-4E58-B265-5BD918426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90518C-8738-45F1-AC93-15B343C23B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44A91A-4213-4C72-BA39-7AA5F9FB2B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50BDA-76B4-4822-B66E-227C034C4F4A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9E617-BCFD-4656-9DE7-A49C6C5C00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573A5-3531-4E04-A6E5-7E0AAB17AE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5CCCE3-7FCC-4F32-8ED1-2AA12B1A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008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microsoft.com/office/2007/relationships/hdphoto" Target="../media/hdphoto8.wdp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microsoft.com/office/2007/relationships/hdphoto" Target="../media/hdphoto14.wdp"/><Relationship Id="rId18" Type="http://schemas.openxmlformats.org/officeDocument/2006/relationships/image" Target="../media/image19.png"/><Relationship Id="rId3" Type="http://schemas.microsoft.com/office/2007/relationships/hdphoto" Target="../media/hdphoto10.wdp"/><Relationship Id="rId7" Type="http://schemas.microsoft.com/office/2007/relationships/hdphoto" Target="../media/hdphoto12.wdp"/><Relationship Id="rId12" Type="http://schemas.openxmlformats.org/officeDocument/2006/relationships/image" Target="../media/image16.png"/><Relationship Id="rId17" Type="http://schemas.microsoft.com/office/2007/relationships/hdphoto" Target="../media/hdphoto16.wdp"/><Relationship Id="rId2" Type="http://schemas.openxmlformats.org/officeDocument/2006/relationships/image" Target="../media/image10.png"/><Relationship Id="rId16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5.png"/><Relationship Id="rId5" Type="http://schemas.microsoft.com/office/2007/relationships/hdphoto" Target="../media/hdphoto11.wdp"/><Relationship Id="rId15" Type="http://schemas.microsoft.com/office/2007/relationships/hdphoto" Target="../media/hdphoto15.wdp"/><Relationship Id="rId10" Type="http://schemas.microsoft.com/office/2007/relationships/hdphoto" Target="../media/hdphoto13.wdp"/><Relationship Id="rId19" Type="http://schemas.microsoft.com/office/2007/relationships/hdphoto" Target="../media/hdphoto17.wdp"/><Relationship Id="rId4" Type="http://schemas.openxmlformats.org/officeDocument/2006/relationships/image" Target="../media/image11.png"/><Relationship Id="rId9" Type="http://schemas.openxmlformats.org/officeDocument/2006/relationships/image" Target="../media/image14.png"/><Relationship Id="rId1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microsoft.com/office/2007/relationships/hdphoto" Target="../media/hdphoto22.wdp"/><Relationship Id="rId3" Type="http://schemas.microsoft.com/office/2007/relationships/hdphoto" Target="../media/hdphoto18.wdp"/><Relationship Id="rId7" Type="http://schemas.microsoft.com/office/2007/relationships/hdphoto" Target="../media/hdphoto20.wdp"/><Relationship Id="rId12" Type="http://schemas.openxmlformats.org/officeDocument/2006/relationships/image" Target="../media/image26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microsoft.com/office/2007/relationships/hdphoto" Target="../media/hdphoto21.wdp"/><Relationship Id="rId5" Type="http://schemas.microsoft.com/office/2007/relationships/hdphoto" Target="../media/hdphoto19.wdp"/><Relationship Id="rId10" Type="http://schemas.openxmlformats.org/officeDocument/2006/relationships/image" Target="../media/image25.png"/><Relationship Id="rId4" Type="http://schemas.openxmlformats.org/officeDocument/2006/relationships/image" Target="../media/image21.png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microsoft.com/office/2007/relationships/hdphoto" Target="../media/hdphoto23.wdp"/><Relationship Id="rId7" Type="http://schemas.microsoft.com/office/2007/relationships/hdphoto" Target="../media/hdphoto25.wdp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microsoft.com/office/2007/relationships/hdphoto" Target="../media/hdphoto27.wdp"/><Relationship Id="rId5" Type="http://schemas.microsoft.com/office/2007/relationships/hdphoto" Target="../media/hdphoto24.wdp"/><Relationship Id="rId10" Type="http://schemas.openxmlformats.org/officeDocument/2006/relationships/image" Target="../media/image31.png"/><Relationship Id="rId4" Type="http://schemas.openxmlformats.org/officeDocument/2006/relationships/image" Target="../media/image28.png"/><Relationship Id="rId9" Type="http://schemas.microsoft.com/office/2007/relationships/hdphoto" Target="../media/hdphoto26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microsoft.com/office/2007/relationships/hdphoto" Target="../media/hdphoto33.wdp"/><Relationship Id="rId3" Type="http://schemas.microsoft.com/office/2007/relationships/hdphoto" Target="../media/hdphoto28.wdp"/><Relationship Id="rId7" Type="http://schemas.microsoft.com/office/2007/relationships/hdphoto" Target="../media/hdphoto30.wdp"/><Relationship Id="rId12" Type="http://schemas.openxmlformats.org/officeDocument/2006/relationships/image" Target="../media/image37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11" Type="http://schemas.microsoft.com/office/2007/relationships/hdphoto" Target="../media/hdphoto32.wdp"/><Relationship Id="rId5" Type="http://schemas.microsoft.com/office/2007/relationships/hdphoto" Target="../media/hdphoto29.wdp"/><Relationship Id="rId15" Type="http://schemas.microsoft.com/office/2007/relationships/hdphoto" Target="../media/hdphoto34.wdp"/><Relationship Id="rId10" Type="http://schemas.openxmlformats.org/officeDocument/2006/relationships/image" Target="../media/image36.png"/><Relationship Id="rId4" Type="http://schemas.openxmlformats.org/officeDocument/2006/relationships/image" Target="../media/image33.png"/><Relationship Id="rId9" Type="http://schemas.microsoft.com/office/2007/relationships/hdphoto" Target="../media/hdphoto31.wdp"/><Relationship Id="rId14" Type="http://schemas.openxmlformats.org/officeDocument/2006/relationships/image" Target="../media/image38.pn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37.wdp"/><Relationship Id="rId13" Type="http://schemas.openxmlformats.org/officeDocument/2006/relationships/image" Target="../media/image44.png"/><Relationship Id="rId3" Type="http://schemas.openxmlformats.org/officeDocument/2006/relationships/image" Target="../media/image39.png"/><Relationship Id="rId7" Type="http://schemas.openxmlformats.org/officeDocument/2006/relationships/image" Target="../media/image41.png"/><Relationship Id="rId12" Type="http://schemas.microsoft.com/office/2007/relationships/hdphoto" Target="../media/hdphoto39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36.wdp"/><Relationship Id="rId11" Type="http://schemas.openxmlformats.org/officeDocument/2006/relationships/image" Target="../media/image43.png"/><Relationship Id="rId5" Type="http://schemas.openxmlformats.org/officeDocument/2006/relationships/image" Target="../media/image40.png"/><Relationship Id="rId10" Type="http://schemas.microsoft.com/office/2007/relationships/hdphoto" Target="../media/hdphoto38.wdp"/><Relationship Id="rId4" Type="http://schemas.microsoft.com/office/2007/relationships/hdphoto" Target="../media/hdphoto35.wdp"/><Relationship Id="rId9" Type="http://schemas.openxmlformats.org/officeDocument/2006/relationships/image" Target="../media/image42.png"/><Relationship Id="rId14" Type="http://schemas.microsoft.com/office/2007/relationships/hdphoto" Target="../media/hdphoto40.wdp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43.wdp"/><Relationship Id="rId13" Type="http://schemas.openxmlformats.org/officeDocument/2006/relationships/image" Target="../media/image50.png"/><Relationship Id="rId3" Type="http://schemas.openxmlformats.org/officeDocument/2006/relationships/image" Target="../media/image45.png"/><Relationship Id="rId7" Type="http://schemas.openxmlformats.org/officeDocument/2006/relationships/image" Target="../media/image47.png"/><Relationship Id="rId12" Type="http://schemas.microsoft.com/office/2007/relationships/hdphoto" Target="../media/hdphoto45.wdp"/><Relationship Id="rId2" Type="http://schemas.openxmlformats.org/officeDocument/2006/relationships/notesSlide" Target="../notesSlides/notesSlide2.xml"/><Relationship Id="rId16" Type="http://schemas.microsoft.com/office/2007/relationships/hdphoto" Target="../media/hdphoto4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42.wdp"/><Relationship Id="rId11" Type="http://schemas.openxmlformats.org/officeDocument/2006/relationships/image" Target="../media/image49.png"/><Relationship Id="rId5" Type="http://schemas.openxmlformats.org/officeDocument/2006/relationships/image" Target="../media/image46.png"/><Relationship Id="rId15" Type="http://schemas.openxmlformats.org/officeDocument/2006/relationships/image" Target="../media/image51.png"/><Relationship Id="rId10" Type="http://schemas.microsoft.com/office/2007/relationships/hdphoto" Target="../media/hdphoto44.wdp"/><Relationship Id="rId4" Type="http://schemas.microsoft.com/office/2007/relationships/hdphoto" Target="../media/hdphoto41.wdp"/><Relationship Id="rId9" Type="http://schemas.openxmlformats.org/officeDocument/2006/relationships/image" Target="../media/image48.png"/><Relationship Id="rId14" Type="http://schemas.microsoft.com/office/2007/relationships/hdphoto" Target="../media/hdphoto4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6DE17D8-028C-4813-AA29-39AE6B26E207}"/>
              </a:ext>
            </a:extLst>
          </p:cNvPr>
          <p:cNvSpPr txBox="1"/>
          <p:nvPr/>
        </p:nvSpPr>
        <p:spPr>
          <a:xfrm>
            <a:off x="1267236" y="578364"/>
            <a:ext cx="2474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2 F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998CD702-37FD-4BE3-AFAA-8343C5AFA84D}"/>
              </a:ext>
            </a:extLst>
          </p:cNvPr>
          <p:cNvGrpSpPr/>
          <p:nvPr/>
        </p:nvGrpSpPr>
        <p:grpSpPr>
          <a:xfrm>
            <a:off x="3711315" y="515041"/>
            <a:ext cx="4179100" cy="793430"/>
            <a:chOff x="3313265" y="1493664"/>
            <a:chExt cx="4179100" cy="79343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AA213C5-5DF7-4389-8B13-5D702FFDEF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58000"/>
                      </a14:imgEffect>
                    </a14:imgLayer>
                  </a14:imgProps>
                </a:ext>
              </a:extLst>
            </a:blip>
            <a:srcRect l="9772" t="34922"/>
            <a:stretch/>
          </p:blipFill>
          <p:spPr>
            <a:xfrm>
              <a:off x="3496056" y="1493664"/>
              <a:ext cx="3996309" cy="79343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A838FAF-DE36-4B93-ABA5-EED1AC7BDE22}"/>
                </a:ext>
              </a:extLst>
            </p:cNvPr>
            <p:cNvSpPr txBox="1"/>
            <p:nvPr/>
          </p:nvSpPr>
          <p:spPr>
            <a:xfrm>
              <a:off x="3313265" y="1581442"/>
              <a:ext cx="10789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P94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7BCBF26-4ADC-4A79-B5ED-78CFB0E5C985}"/>
                </a:ext>
              </a:extLst>
            </p:cNvPr>
            <p:cNvSpPr txBox="1"/>
            <p:nvPr/>
          </p:nvSpPr>
          <p:spPr>
            <a:xfrm>
              <a:off x="4370451" y="1589915"/>
              <a:ext cx="2496312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5D1039ED-9E0F-40BC-BB00-5C8CA8902E2F}"/>
              </a:ext>
            </a:extLst>
          </p:cNvPr>
          <p:cNvGrpSpPr/>
          <p:nvPr/>
        </p:nvGrpSpPr>
        <p:grpSpPr>
          <a:xfrm>
            <a:off x="3651534" y="1921296"/>
            <a:ext cx="4787331" cy="2372536"/>
            <a:chOff x="1514407" y="2842898"/>
            <a:chExt cx="4787331" cy="2372536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CF9F8DA7-6052-4A51-B753-337A117FF151}"/>
                </a:ext>
              </a:extLst>
            </p:cNvPr>
            <p:cNvGrpSpPr/>
            <p:nvPr/>
          </p:nvGrpSpPr>
          <p:grpSpPr>
            <a:xfrm>
              <a:off x="1796413" y="2842898"/>
              <a:ext cx="4505325" cy="2372536"/>
              <a:chOff x="1856706" y="1723739"/>
              <a:chExt cx="4505325" cy="2372536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BF5E37E1-9822-45FE-9BCD-169286480BA5}"/>
                  </a:ext>
                </a:extLst>
              </p:cNvPr>
              <p:cNvGrpSpPr/>
              <p:nvPr/>
            </p:nvGrpSpPr>
            <p:grpSpPr>
              <a:xfrm>
                <a:off x="1856706" y="1723739"/>
                <a:ext cx="4505325" cy="2372536"/>
                <a:chOff x="1380363" y="2264320"/>
                <a:chExt cx="4505325" cy="2372536"/>
              </a:xfrm>
            </p:grpSpPr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8660BF0A-3A14-472C-BC70-0B126CA8782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0000" contrast="55000"/>
                          </a14:imgEffect>
                        </a14:imgLayer>
                      </a14:imgProps>
                    </a:ext>
                  </a:extLst>
                </a:blip>
                <a:srcRect t="11658" b="11226"/>
                <a:stretch/>
              </p:blipFill>
              <p:spPr>
                <a:xfrm>
                  <a:off x="1380363" y="2264320"/>
                  <a:ext cx="4505325" cy="2372536"/>
                </a:xfrm>
                <a:prstGeom prst="rect">
                  <a:avLst/>
                </a:prstGeom>
              </p:spPr>
            </p:pic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E0777E57-B716-4BBA-A219-5D42289E5A0A}"/>
                    </a:ext>
                  </a:extLst>
                </p:cNvPr>
                <p:cNvSpPr txBox="1"/>
                <p:nvPr/>
              </p:nvSpPr>
              <p:spPr>
                <a:xfrm>
                  <a:off x="2215324" y="2468880"/>
                  <a:ext cx="2566988" cy="36956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2E46D6CA-05FF-40D3-95E4-5C284AF8CCF7}"/>
                  </a:ext>
                </a:extLst>
              </p:cNvPr>
              <p:cNvSpPr txBox="1"/>
              <p:nvPr/>
            </p:nvSpPr>
            <p:spPr>
              <a:xfrm>
                <a:off x="2715768" y="3416938"/>
                <a:ext cx="2586228" cy="64633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  <a:p>
                <a:endParaRPr lang="en-US" dirty="0"/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7FFC1C1-CCB0-4A33-B7D0-D3E942B72ACB}"/>
                </a:ext>
              </a:extLst>
            </p:cNvPr>
            <p:cNvSpPr txBox="1"/>
            <p:nvPr/>
          </p:nvSpPr>
          <p:spPr>
            <a:xfrm>
              <a:off x="1527998" y="3045618"/>
              <a:ext cx="1216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AKT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D949DB8-7A44-49F2-9401-4106A8E8521E}"/>
                </a:ext>
              </a:extLst>
            </p:cNvPr>
            <p:cNvSpPr txBox="1"/>
            <p:nvPr/>
          </p:nvSpPr>
          <p:spPr>
            <a:xfrm>
              <a:off x="1514407" y="4684314"/>
              <a:ext cx="96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-Cas3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5448B9E-A25C-4DB4-B3BB-EC8203CCC046}"/>
              </a:ext>
            </a:extLst>
          </p:cNvPr>
          <p:cNvGrpSpPr/>
          <p:nvPr/>
        </p:nvGrpSpPr>
        <p:grpSpPr>
          <a:xfrm>
            <a:off x="3617991" y="1277124"/>
            <a:ext cx="4773740" cy="623087"/>
            <a:chOff x="1575835" y="1710066"/>
            <a:chExt cx="4667250" cy="61912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60B1B4C-F682-4D4B-888E-8C5310733B4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3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575835" y="1710066"/>
              <a:ext cx="4667250" cy="619125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A48A441-6C4D-4ABD-BAD8-F9FEEB03B5C8}"/>
                </a:ext>
              </a:extLst>
            </p:cNvPr>
            <p:cNvSpPr txBox="1"/>
            <p:nvPr/>
          </p:nvSpPr>
          <p:spPr>
            <a:xfrm>
              <a:off x="2744149" y="1947007"/>
              <a:ext cx="2466256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5ED4D6C-0562-40D2-88CC-39F66AC2CD17}"/>
                </a:ext>
              </a:extLst>
            </p:cNvPr>
            <p:cNvSpPr txBox="1"/>
            <p:nvPr/>
          </p:nvSpPr>
          <p:spPr>
            <a:xfrm>
              <a:off x="1696825" y="1825057"/>
              <a:ext cx="9842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P78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A939A2FE-3F19-41B0-89F6-A21D5C8178DE}"/>
              </a:ext>
            </a:extLst>
          </p:cNvPr>
          <p:cNvGrpSpPr/>
          <p:nvPr/>
        </p:nvGrpSpPr>
        <p:grpSpPr>
          <a:xfrm>
            <a:off x="3622262" y="4297716"/>
            <a:ext cx="4752975" cy="632948"/>
            <a:chOff x="1536194" y="4986053"/>
            <a:chExt cx="4752975" cy="63294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75559FE-D472-4DFC-9FB2-4DBC706BAB2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67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536194" y="4986053"/>
              <a:ext cx="4752975" cy="632948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A142D7A-8595-4F94-A565-3DFC909631D4}"/>
                </a:ext>
              </a:extLst>
            </p:cNvPr>
            <p:cNvSpPr txBox="1"/>
            <p:nvPr/>
          </p:nvSpPr>
          <p:spPr>
            <a:xfrm>
              <a:off x="2704239" y="5021539"/>
              <a:ext cx="2566989" cy="56197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C0AF93E-BB91-4906-863E-BE4D07B9F45D}"/>
                </a:ext>
              </a:extLst>
            </p:cNvPr>
            <p:cNvSpPr txBox="1"/>
            <p:nvPr/>
          </p:nvSpPr>
          <p:spPr>
            <a:xfrm>
              <a:off x="1602203" y="5177478"/>
              <a:ext cx="8503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KT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12A17A22-BAC9-4632-B870-E36F769CA210}"/>
              </a:ext>
            </a:extLst>
          </p:cNvPr>
          <p:cNvGrpSpPr/>
          <p:nvPr/>
        </p:nvGrpSpPr>
        <p:grpSpPr>
          <a:xfrm>
            <a:off x="3650563" y="4916261"/>
            <a:ext cx="5025678" cy="776486"/>
            <a:chOff x="1498634" y="5654487"/>
            <a:chExt cx="5006008" cy="79180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13EDF5C-05FC-4120-9742-7177593936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8000" contrast="61000"/>
                      </a14:imgEffect>
                    </a14:imgLayer>
                  </a14:imgProps>
                </a:ext>
              </a:extLst>
            </a:blip>
            <a:srcRect l="13370"/>
            <a:stretch/>
          </p:blipFill>
          <p:spPr>
            <a:xfrm>
              <a:off x="1498634" y="5654487"/>
              <a:ext cx="5006008" cy="791807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3C62333-7DB3-4B14-B9B4-5A4D6EFB097A}"/>
                </a:ext>
              </a:extLst>
            </p:cNvPr>
            <p:cNvSpPr txBox="1"/>
            <p:nvPr/>
          </p:nvSpPr>
          <p:spPr>
            <a:xfrm>
              <a:off x="1601784" y="5774939"/>
              <a:ext cx="13038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Bim</a:t>
              </a:r>
              <a:endParaRPr lang="en-US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E6A37FB-0EAF-4497-9528-197DAD58A1E6}"/>
                </a:ext>
              </a:extLst>
            </p:cNvPr>
            <p:cNvSpPr txBox="1"/>
            <p:nvPr/>
          </p:nvSpPr>
          <p:spPr>
            <a:xfrm>
              <a:off x="2642870" y="5769402"/>
              <a:ext cx="2590798" cy="56197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pic>
        <p:nvPicPr>
          <p:cNvPr id="31" name="Picture 30">
            <a:extLst>
              <a:ext uri="{FF2B5EF4-FFF2-40B4-BE49-F238E27FC236}">
                <a16:creationId xmlns:a16="http://schemas.microsoft.com/office/drawing/2014/main" id="{4B5EF60F-0CEA-4942-973D-7226CABBBAC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149" t="77503" r="149" b="565"/>
          <a:stretch/>
        </p:blipFill>
        <p:spPr>
          <a:xfrm>
            <a:off x="3717933" y="5729296"/>
            <a:ext cx="4735566" cy="937748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EC2204D7-C6AC-4B72-A16E-08E8EACE331B}"/>
              </a:ext>
            </a:extLst>
          </p:cNvPr>
          <p:cNvSpPr txBox="1"/>
          <p:nvPr/>
        </p:nvSpPr>
        <p:spPr>
          <a:xfrm>
            <a:off x="4885713" y="5956886"/>
            <a:ext cx="2552268" cy="5511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C40A2EC-9C58-4F02-BE88-85C5485BF9BD}"/>
              </a:ext>
            </a:extLst>
          </p:cNvPr>
          <p:cNvSpPr txBox="1"/>
          <p:nvPr/>
        </p:nvSpPr>
        <p:spPr>
          <a:xfrm>
            <a:off x="3624952" y="5971666"/>
            <a:ext cx="1426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Lucida Grande"/>
                <a:cs typeface="Calibri" panose="020F0502020204030204" pitchFamily="34" charset="0"/>
              </a:rPr>
              <a:t>β</a:t>
            </a:r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44DA588-44A3-4985-B6FB-076591623198}"/>
              </a:ext>
            </a:extLst>
          </p:cNvPr>
          <p:cNvSpPr/>
          <p:nvPr/>
        </p:nvSpPr>
        <p:spPr>
          <a:xfrm>
            <a:off x="123562" y="-25384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9291215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BED3A29-504A-4125-9D55-AF0F6134C7CE}"/>
              </a:ext>
            </a:extLst>
          </p:cNvPr>
          <p:cNvSpPr txBox="1"/>
          <p:nvPr/>
        </p:nvSpPr>
        <p:spPr>
          <a:xfrm>
            <a:off x="550189" y="432915"/>
            <a:ext cx="2139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 2G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94BCE67-D486-438B-9DF4-ADBB21BBDC23}"/>
              </a:ext>
            </a:extLst>
          </p:cNvPr>
          <p:cNvGrpSpPr/>
          <p:nvPr/>
        </p:nvGrpSpPr>
        <p:grpSpPr>
          <a:xfrm>
            <a:off x="2660311" y="758048"/>
            <a:ext cx="4590477" cy="805756"/>
            <a:chOff x="2361296" y="520943"/>
            <a:chExt cx="4590477" cy="805756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DDE5B386-F83D-4DE0-A1A1-3AAEF37134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9000"/>
                      </a14:imgEffect>
                    </a14:imgLayer>
                  </a14:imgProps>
                </a:ext>
              </a:extLst>
            </a:blip>
            <a:srcRect r="3498"/>
            <a:stretch/>
          </p:blipFill>
          <p:spPr>
            <a:xfrm>
              <a:off x="2361296" y="520943"/>
              <a:ext cx="4590477" cy="805756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B568399-B34E-4AFB-A04C-F32519041996}"/>
                </a:ext>
              </a:extLst>
            </p:cNvPr>
            <p:cNvSpPr txBox="1"/>
            <p:nvPr/>
          </p:nvSpPr>
          <p:spPr>
            <a:xfrm>
              <a:off x="3218688" y="548640"/>
              <a:ext cx="2659814" cy="65736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5D4F1E0-D4AB-4C28-A047-EC83202520DD}"/>
                </a:ext>
              </a:extLst>
            </p:cNvPr>
            <p:cNvSpPr txBox="1"/>
            <p:nvPr/>
          </p:nvSpPr>
          <p:spPr>
            <a:xfrm>
              <a:off x="2390870" y="749808"/>
              <a:ext cx="10426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P94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51C44989-80E4-4A82-B2CC-193FBB383155}"/>
              </a:ext>
            </a:extLst>
          </p:cNvPr>
          <p:cNvGrpSpPr/>
          <p:nvPr/>
        </p:nvGrpSpPr>
        <p:grpSpPr>
          <a:xfrm>
            <a:off x="2660310" y="1598847"/>
            <a:ext cx="4590478" cy="686757"/>
            <a:chOff x="2331720" y="1608388"/>
            <a:chExt cx="4590478" cy="686757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215C302C-DDF8-4372-BE6A-B35AC345B6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6000" contrast="42000"/>
                      </a14:imgEffect>
                    </a14:imgLayer>
                  </a14:imgProps>
                </a:ext>
              </a:extLst>
            </a:blip>
            <a:srcRect l="2835"/>
            <a:stretch/>
          </p:blipFill>
          <p:spPr>
            <a:xfrm>
              <a:off x="2331720" y="1608389"/>
              <a:ext cx="4590478" cy="686756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CDB0666-C30A-4131-AC6E-EAF9A6FEF102}"/>
                </a:ext>
              </a:extLst>
            </p:cNvPr>
            <p:cNvSpPr txBox="1"/>
            <p:nvPr/>
          </p:nvSpPr>
          <p:spPr>
            <a:xfrm>
              <a:off x="3218688" y="1608388"/>
              <a:ext cx="2630239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C64B2FE-203A-4D20-BAE5-064FB88E6244}"/>
                </a:ext>
              </a:extLst>
            </p:cNvPr>
            <p:cNvSpPr txBox="1"/>
            <p:nvPr/>
          </p:nvSpPr>
          <p:spPr>
            <a:xfrm>
              <a:off x="2514600" y="1739213"/>
              <a:ext cx="5577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Bim</a:t>
              </a:r>
              <a:endParaRPr lang="en-US" dirty="0"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C344776D-A2DF-4029-AE1E-9007B5BAF073}"/>
              </a:ext>
            </a:extLst>
          </p:cNvPr>
          <p:cNvGrpSpPr/>
          <p:nvPr/>
        </p:nvGrpSpPr>
        <p:grpSpPr>
          <a:xfrm>
            <a:off x="2820608" y="2411950"/>
            <a:ext cx="4733925" cy="902447"/>
            <a:chOff x="2789659" y="2618690"/>
            <a:chExt cx="4733925" cy="902447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D7D7B008-F161-4440-A427-A36632F38C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t="23270" b="36364"/>
            <a:stretch/>
          </p:blipFill>
          <p:spPr>
            <a:xfrm>
              <a:off x="2789659" y="2618690"/>
              <a:ext cx="4733925" cy="902447"/>
            </a:xfrm>
            <a:prstGeom prst="rect">
              <a:avLst/>
            </a:prstGeom>
          </p:spPr>
        </p:pic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73F8171C-60CB-4CA0-BBD4-95A06459EF02}"/>
                </a:ext>
              </a:extLst>
            </p:cNvPr>
            <p:cNvGrpSpPr/>
            <p:nvPr/>
          </p:nvGrpSpPr>
          <p:grpSpPr>
            <a:xfrm>
              <a:off x="2789659" y="2888000"/>
              <a:ext cx="3463234" cy="434983"/>
              <a:chOff x="2461069" y="2650895"/>
              <a:chExt cx="3463234" cy="434983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AB2AA07-C725-4E80-A362-1CB2376B96D6}"/>
                  </a:ext>
                </a:extLst>
              </p:cNvPr>
              <p:cNvSpPr txBox="1"/>
              <p:nvPr/>
            </p:nvSpPr>
            <p:spPr>
              <a:xfrm>
                <a:off x="3187739" y="2673660"/>
                <a:ext cx="2736564" cy="41221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16B9D6D-B8DF-4D1C-97C6-C462D9559FCA}"/>
                  </a:ext>
                </a:extLst>
              </p:cNvPr>
              <p:cNvSpPr txBox="1"/>
              <p:nvPr/>
            </p:nvSpPr>
            <p:spPr>
              <a:xfrm>
                <a:off x="2461069" y="2650895"/>
                <a:ext cx="122262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-Cas3</a:t>
                </a:r>
              </a:p>
            </p:txBody>
          </p:sp>
        </p:grp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F6AB682E-5CE7-48B6-B9B4-883CEEF9BBED}"/>
              </a:ext>
            </a:extLst>
          </p:cNvPr>
          <p:cNvSpPr/>
          <p:nvPr/>
        </p:nvSpPr>
        <p:spPr>
          <a:xfrm>
            <a:off x="0" y="63583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2939554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FA29021-3DA7-401F-B01E-197F21AEE7AD}"/>
              </a:ext>
            </a:extLst>
          </p:cNvPr>
          <p:cNvSpPr txBox="1"/>
          <p:nvPr/>
        </p:nvSpPr>
        <p:spPr>
          <a:xfrm>
            <a:off x="1018006" y="457753"/>
            <a:ext cx="1060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C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574879DE-FDBD-4964-82DF-3915894F0829}"/>
              </a:ext>
            </a:extLst>
          </p:cNvPr>
          <p:cNvGrpSpPr/>
          <p:nvPr/>
        </p:nvGrpSpPr>
        <p:grpSpPr>
          <a:xfrm>
            <a:off x="1625710" y="989814"/>
            <a:ext cx="4009180" cy="4639904"/>
            <a:chOff x="2003123" y="556181"/>
            <a:chExt cx="4009180" cy="4639904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7DF5AAF6-C04A-4253-8833-82FCAAF6396B}"/>
                </a:ext>
              </a:extLst>
            </p:cNvPr>
            <p:cNvGrpSpPr/>
            <p:nvPr/>
          </p:nvGrpSpPr>
          <p:grpSpPr>
            <a:xfrm>
              <a:off x="2078710" y="556181"/>
              <a:ext cx="3892349" cy="1387614"/>
              <a:chOff x="2078710" y="556181"/>
              <a:chExt cx="3892349" cy="1387614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18AF2F76-1202-4B59-A3AE-69093A0B7CA4}"/>
                  </a:ext>
                </a:extLst>
              </p:cNvPr>
              <p:cNvGrpSpPr/>
              <p:nvPr/>
            </p:nvGrpSpPr>
            <p:grpSpPr>
              <a:xfrm>
                <a:off x="2794226" y="556181"/>
                <a:ext cx="3176833" cy="1387614"/>
                <a:chOff x="2794226" y="556181"/>
                <a:chExt cx="3176833" cy="1387614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A657E9D2-9210-4E87-9285-1509F701BD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4000" contrast="51000"/>
                          </a14:imgEffect>
                        </a14:imgLayer>
                      </a14:imgProps>
                    </a:ext>
                  </a:extLst>
                </a:blip>
                <a:srcRect l="9131" t="3527" r="56199" b="70000"/>
                <a:stretch/>
              </p:blipFill>
              <p:spPr>
                <a:xfrm>
                  <a:off x="2794226" y="556181"/>
                  <a:ext cx="3176833" cy="1387614"/>
                </a:xfrm>
                <a:prstGeom prst="rect">
                  <a:avLst/>
                </a:prstGeom>
              </p:spPr>
            </p:pic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89B4A2C3-C187-4E87-A9ED-D50EC6E327B2}"/>
                    </a:ext>
                  </a:extLst>
                </p:cNvPr>
                <p:cNvSpPr txBox="1"/>
                <p:nvPr/>
              </p:nvSpPr>
              <p:spPr>
                <a:xfrm>
                  <a:off x="3355942" y="1424256"/>
                  <a:ext cx="1736103" cy="38649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4FE2520-7F56-4465-997C-3935189AD7E5}"/>
                  </a:ext>
                </a:extLst>
              </p:cNvPr>
              <p:cNvSpPr txBox="1"/>
              <p:nvPr/>
            </p:nvSpPr>
            <p:spPr>
              <a:xfrm>
                <a:off x="2078710" y="1439433"/>
                <a:ext cx="10607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GRP94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D064812C-1A52-4729-96BF-0D9697C4BA8B}"/>
                </a:ext>
              </a:extLst>
            </p:cNvPr>
            <p:cNvGrpSpPr/>
            <p:nvPr/>
          </p:nvGrpSpPr>
          <p:grpSpPr>
            <a:xfrm>
              <a:off x="2142960" y="1963155"/>
              <a:ext cx="3815321" cy="608185"/>
              <a:chOff x="2142960" y="1963155"/>
              <a:chExt cx="3815321" cy="608185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DDBF6B48-824E-43B9-BF5D-A635E2355A17}"/>
                  </a:ext>
                </a:extLst>
              </p:cNvPr>
              <p:cNvGrpSpPr/>
              <p:nvPr/>
            </p:nvGrpSpPr>
            <p:grpSpPr>
              <a:xfrm>
                <a:off x="2781448" y="1963155"/>
                <a:ext cx="3176833" cy="608185"/>
                <a:chOff x="2781448" y="1963155"/>
                <a:chExt cx="3176833" cy="608185"/>
              </a:xfrm>
            </p:grpSpPr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201FFD6E-93A2-495C-95F4-E22E18931C9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8000" contrast="28000"/>
                          </a14:imgEffect>
                        </a14:imgLayer>
                      </a14:imgProps>
                    </a:ext>
                  </a:extLst>
                </a:blip>
                <a:srcRect l="20659" t="25320" r="8679" b="61702"/>
                <a:stretch/>
              </p:blipFill>
              <p:spPr>
                <a:xfrm>
                  <a:off x="2781448" y="1963155"/>
                  <a:ext cx="3176833" cy="608185"/>
                </a:xfrm>
                <a:prstGeom prst="rect">
                  <a:avLst/>
                </a:prstGeom>
              </p:spPr>
            </p:pic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21906C16-AAE1-4B83-90D9-E5BC229987E6}"/>
                    </a:ext>
                  </a:extLst>
                </p:cNvPr>
                <p:cNvSpPr txBox="1"/>
                <p:nvPr/>
              </p:nvSpPr>
              <p:spPr>
                <a:xfrm>
                  <a:off x="3355941" y="2160146"/>
                  <a:ext cx="1736103" cy="38649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CB5929C2-8495-47DF-871D-682FE1A0A6F3}"/>
                  </a:ext>
                </a:extLst>
              </p:cNvPr>
              <p:cNvSpPr txBox="1"/>
              <p:nvPr/>
            </p:nvSpPr>
            <p:spPr>
              <a:xfrm>
                <a:off x="2142960" y="2080176"/>
                <a:ext cx="782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p-AKT</a:t>
                </a: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3D1EB7F5-A5F4-41E6-9C11-D9D130EE9EBE}"/>
                </a:ext>
              </a:extLst>
            </p:cNvPr>
            <p:cNvGrpSpPr/>
            <p:nvPr/>
          </p:nvGrpSpPr>
          <p:grpSpPr>
            <a:xfrm>
              <a:off x="2311800" y="2643301"/>
              <a:ext cx="3659259" cy="608186"/>
              <a:chOff x="2311800" y="2643301"/>
              <a:chExt cx="3659259" cy="608186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C470C095-3800-4937-88E2-BEDB99B4374A}"/>
                  </a:ext>
                </a:extLst>
              </p:cNvPr>
              <p:cNvGrpSpPr/>
              <p:nvPr/>
            </p:nvGrpSpPr>
            <p:grpSpPr>
              <a:xfrm>
                <a:off x="2794226" y="2643301"/>
                <a:ext cx="3176833" cy="608186"/>
                <a:chOff x="2794226" y="2643301"/>
                <a:chExt cx="3176833" cy="608186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6043E210-DC5D-4314-88C1-34D193E8097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1000"/>
                          </a14:imgEffect>
                          <a14:imgEffect>
                            <a14:brightnessContrast bright="30000" contrast="46000"/>
                          </a14:imgEffect>
                        </a14:imgLayer>
                      </a14:imgProps>
                    </a:ext>
                  </a:extLst>
                </a:blip>
                <a:srcRect l="20454" t="44366" r="12031" b="7283"/>
                <a:stretch/>
              </p:blipFill>
              <p:spPr>
                <a:xfrm>
                  <a:off x="2794226" y="2643301"/>
                  <a:ext cx="3176833" cy="608186"/>
                </a:xfrm>
                <a:prstGeom prst="rect">
                  <a:avLst/>
                </a:prstGeom>
              </p:spPr>
            </p:pic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09940EE0-D0C1-48E2-823D-AEA4FACD7451}"/>
                    </a:ext>
                  </a:extLst>
                </p:cNvPr>
                <p:cNvSpPr txBox="1"/>
                <p:nvPr/>
              </p:nvSpPr>
              <p:spPr>
                <a:xfrm>
                  <a:off x="3355941" y="2678830"/>
                  <a:ext cx="1736103" cy="26522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FEE0C52-4931-41C2-A245-AF9F2A33F8D8}"/>
                  </a:ext>
                </a:extLst>
              </p:cNvPr>
              <p:cNvSpPr txBox="1"/>
              <p:nvPr/>
            </p:nvSpPr>
            <p:spPr>
              <a:xfrm>
                <a:off x="2311800" y="2716415"/>
                <a:ext cx="67728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AKT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752E4A19-35BE-4100-8C7D-51A90F684C56}"/>
                </a:ext>
              </a:extLst>
            </p:cNvPr>
            <p:cNvGrpSpPr/>
            <p:nvPr/>
          </p:nvGrpSpPr>
          <p:grpSpPr>
            <a:xfrm>
              <a:off x="2078710" y="3323448"/>
              <a:ext cx="3879571" cy="537331"/>
              <a:chOff x="2078710" y="3323448"/>
              <a:chExt cx="3879571" cy="537331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26CE0B8E-626C-4B00-A645-AAB89C30AB11}"/>
                  </a:ext>
                </a:extLst>
              </p:cNvPr>
              <p:cNvGrpSpPr/>
              <p:nvPr/>
            </p:nvGrpSpPr>
            <p:grpSpPr>
              <a:xfrm>
                <a:off x="2794226" y="3323448"/>
                <a:ext cx="3164055" cy="537331"/>
                <a:chOff x="2794226" y="3323448"/>
                <a:chExt cx="3164055" cy="537331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0B3342C3-FC71-4AAA-A4C8-63597618AE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38000" contrast="43000"/>
                          </a14:imgEffect>
                        </a14:imgLayer>
                      </a14:imgProps>
                    </a:ext>
                  </a:extLst>
                </a:blip>
                <a:srcRect l="21727" t="84643" r="10819" b="-334"/>
                <a:stretch/>
              </p:blipFill>
              <p:spPr>
                <a:xfrm>
                  <a:off x="2794226" y="3323448"/>
                  <a:ext cx="3164055" cy="537331"/>
                </a:xfrm>
                <a:prstGeom prst="rect">
                  <a:avLst/>
                </a:prstGeom>
              </p:spPr>
            </p:pic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F455F6A2-E49C-48A9-BE38-5CD3BB26DF62}"/>
                    </a:ext>
                  </a:extLst>
                </p:cNvPr>
                <p:cNvSpPr txBox="1"/>
                <p:nvPr/>
              </p:nvSpPr>
              <p:spPr>
                <a:xfrm>
                  <a:off x="3399146" y="3415933"/>
                  <a:ext cx="1655190" cy="29865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CA1E49D-11D1-4E0E-A6B1-062980EE7256}"/>
                  </a:ext>
                </a:extLst>
              </p:cNvPr>
              <p:cNvSpPr txBox="1"/>
              <p:nvPr/>
            </p:nvSpPr>
            <p:spPr>
              <a:xfrm>
                <a:off x="2078710" y="3402793"/>
                <a:ext cx="83298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-Cas3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4918A317-B20A-475B-8BE3-A25714E9D30D}"/>
                </a:ext>
              </a:extLst>
            </p:cNvPr>
            <p:cNvGrpSpPr/>
            <p:nvPr/>
          </p:nvGrpSpPr>
          <p:grpSpPr>
            <a:xfrm>
              <a:off x="2273102" y="3879033"/>
              <a:ext cx="3739201" cy="608186"/>
              <a:chOff x="2273102" y="3879033"/>
              <a:chExt cx="3739201" cy="608186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478A853C-E160-420D-BA2D-7D87638DD42F}"/>
                  </a:ext>
                </a:extLst>
              </p:cNvPr>
              <p:cNvGrpSpPr/>
              <p:nvPr/>
            </p:nvGrpSpPr>
            <p:grpSpPr>
              <a:xfrm>
                <a:off x="2752981" y="3879033"/>
                <a:ext cx="3259322" cy="608186"/>
                <a:chOff x="2752981" y="3879033"/>
                <a:chExt cx="3259322" cy="608186"/>
              </a:xfrm>
            </p:grpSpPr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1BB8E8EA-91A7-40EA-8814-B392E1FB77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37000" contrast="58000"/>
                          </a14:imgEffect>
                        </a14:imgLayer>
                      </a14:imgProps>
                    </a:ext>
                  </a:extLst>
                </a:blip>
                <a:srcRect l="20552" t="12550" r="8455" b="24518"/>
                <a:stretch/>
              </p:blipFill>
              <p:spPr>
                <a:xfrm>
                  <a:off x="2752981" y="3879033"/>
                  <a:ext cx="3259322" cy="608186"/>
                </a:xfrm>
                <a:prstGeom prst="rect">
                  <a:avLst/>
                </a:prstGeom>
              </p:spPr>
            </p:pic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619297F2-4C45-4BAB-9BC6-5543F5FCA4A1}"/>
                    </a:ext>
                  </a:extLst>
                </p:cNvPr>
                <p:cNvSpPr txBox="1"/>
                <p:nvPr/>
              </p:nvSpPr>
              <p:spPr>
                <a:xfrm>
                  <a:off x="3355941" y="3991420"/>
                  <a:ext cx="1736103" cy="28251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65092C0-7C8E-4C5F-8FEE-CF596BDB013D}"/>
                  </a:ext>
                </a:extLst>
              </p:cNvPr>
              <p:cNvSpPr txBox="1"/>
              <p:nvPr/>
            </p:nvSpPr>
            <p:spPr>
              <a:xfrm>
                <a:off x="2273102" y="3998460"/>
                <a:ext cx="88612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/>
                  <a:t>Bim</a:t>
                </a:r>
                <a:endParaRPr lang="en-US" dirty="0"/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5D3FF7CA-4B49-445C-94A2-86ADC901CDC6}"/>
                </a:ext>
              </a:extLst>
            </p:cNvPr>
            <p:cNvGrpSpPr/>
            <p:nvPr/>
          </p:nvGrpSpPr>
          <p:grpSpPr>
            <a:xfrm>
              <a:off x="2003123" y="4538083"/>
              <a:ext cx="3967936" cy="658002"/>
              <a:chOff x="2003123" y="4538083"/>
              <a:chExt cx="3967936" cy="658002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C68E6B8B-2201-4028-8673-DEAEFD0639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" contrast="48000"/>
                        </a14:imgEffect>
                      </a14:imgLayer>
                    </a14:imgProps>
                  </a:ext>
                </a:extLst>
              </a:blip>
              <a:srcRect l="57273" t="76770" r="8057" b="11153"/>
              <a:stretch/>
            </p:blipFill>
            <p:spPr>
              <a:xfrm>
                <a:off x="2794226" y="4538083"/>
                <a:ext cx="3176833" cy="658002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7B7DF57-9822-4436-B224-272F07881BA0}"/>
                  </a:ext>
                </a:extLst>
              </p:cNvPr>
              <p:cNvSpPr txBox="1"/>
              <p:nvPr/>
            </p:nvSpPr>
            <p:spPr>
              <a:xfrm>
                <a:off x="3355941" y="4672642"/>
                <a:ext cx="1736103" cy="23883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357DF44-0F6C-4A7D-9565-727EB51D42BA}"/>
                  </a:ext>
                </a:extLst>
              </p:cNvPr>
              <p:cNvSpPr txBox="1"/>
              <p:nvPr/>
            </p:nvSpPr>
            <p:spPr>
              <a:xfrm>
                <a:off x="2003123" y="4629398"/>
                <a:ext cx="14260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Calibri" panose="020F0502020204030204" pitchFamily="34" charset="0"/>
                    <a:ea typeface="Lucida Grande"/>
                    <a:cs typeface="Calibri" panose="020F0502020204030204" pitchFamily="34" charset="0"/>
                  </a:rPr>
                  <a:t>β</a:t>
                </a:r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-actin</a:t>
                </a:r>
              </a:p>
            </p:txBody>
          </p:sp>
        </p:grp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952C4B19-0F7D-4CDD-9CA4-81B8FDB343F9}"/>
              </a:ext>
            </a:extLst>
          </p:cNvPr>
          <p:cNvGrpSpPr/>
          <p:nvPr/>
        </p:nvGrpSpPr>
        <p:grpSpPr>
          <a:xfrm>
            <a:off x="5899266" y="983688"/>
            <a:ext cx="4724637" cy="1391065"/>
            <a:chOff x="5899266" y="983688"/>
            <a:chExt cx="4724637" cy="1391065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4C11B734-D9A0-48FB-8047-82153D67D0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29000"/>
                      </a14:imgEffect>
                    </a14:imgLayer>
                  </a14:imgProps>
                </a:ext>
              </a:extLst>
            </a:blip>
            <a:srcRect l="10118" r="9087" b="19317"/>
            <a:stretch/>
          </p:blipFill>
          <p:spPr>
            <a:xfrm>
              <a:off x="6679545" y="983688"/>
              <a:ext cx="3944358" cy="1391065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C13DE10-51FF-4A60-948D-561B01106372}"/>
                </a:ext>
              </a:extLst>
            </p:cNvPr>
            <p:cNvSpPr txBox="1"/>
            <p:nvPr/>
          </p:nvSpPr>
          <p:spPr>
            <a:xfrm>
              <a:off x="7598971" y="1716170"/>
              <a:ext cx="1936335" cy="3864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9E52913-58E6-4E1C-B578-E842B3CAA384}"/>
                </a:ext>
              </a:extLst>
            </p:cNvPr>
            <p:cNvSpPr txBox="1"/>
            <p:nvPr/>
          </p:nvSpPr>
          <p:spPr>
            <a:xfrm>
              <a:off x="5899266" y="1680545"/>
              <a:ext cx="9254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P94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71F31E00-3FAB-43FB-81EC-15FBB4A1F04B}"/>
              </a:ext>
            </a:extLst>
          </p:cNvPr>
          <p:cNvGrpSpPr/>
          <p:nvPr/>
        </p:nvGrpSpPr>
        <p:grpSpPr>
          <a:xfrm>
            <a:off x="6054662" y="2384559"/>
            <a:ext cx="4745918" cy="1260845"/>
            <a:chOff x="6054662" y="2384559"/>
            <a:chExt cx="4745918" cy="1260845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DF0914A8-E79F-40DF-8ECB-2316EFA6C7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53000"/>
                      </a14:imgEffect>
                    </a14:imgLayer>
                  </a14:imgProps>
                </a:ext>
              </a:extLst>
            </a:blip>
            <a:srcRect l="7813" t="11693" r="7168" b="30569"/>
            <a:stretch/>
          </p:blipFill>
          <p:spPr>
            <a:xfrm>
              <a:off x="6679545" y="2384559"/>
              <a:ext cx="4121035" cy="1260845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0689C34-0F11-41D2-B70F-D2426F1F8ED1}"/>
                </a:ext>
              </a:extLst>
            </p:cNvPr>
            <p:cNvSpPr txBox="1"/>
            <p:nvPr/>
          </p:nvSpPr>
          <p:spPr>
            <a:xfrm>
              <a:off x="7598971" y="2835151"/>
              <a:ext cx="1936335" cy="37307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99F1C05-D637-438E-BDEC-E1F4E24E0419}"/>
                </a:ext>
              </a:extLst>
            </p:cNvPr>
            <p:cNvSpPr txBox="1"/>
            <p:nvPr/>
          </p:nvSpPr>
          <p:spPr>
            <a:xfrm>
              <a:off x="6054662" y="2767798"/>
              <a:ext cx="11683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AKT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413D52B5-28EC-402C-8DE0-A4641BB4641D}"/>
              </a:ext>
            </a:extLst>
          </p:cNvPr>
          <p:cNvGrpSpPr/>
          <p:nvPr/>
        </p:nvGrpSpPr>
        <p:grpSpPr>
          <a:xfrm>
            <a:off x="5937271" y="3716432"/>
            <a:ext cx="4686632" cy="749975"/>
            <a:chOff x="5937271" y="3716432"/>
            <a:chExt cx="4686632" cy="749975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07731387-9AFA-4309-95EE-BFBE69C9B9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35000" contrast="68000"/>
                      </a14:imgEffect>
                    </a14:imgLayer>
                  </a14:imgProps>
                </a:ext>
              </a:extLst>
            </a:blip>
            <a:srcRect l="47236" r="3847"/>
            <a:stretch/>
          </p:blipFill>
          <p:spPr>
            <a:xfrm flipH="1">
              <a:off x="6638818" y="3716432"/>
              <a:ext cx="3985085" cy="749975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50290A9-D585-4C19-8419-B556B8A78C62}"/>
                </a:ext>
              </a:extLst>
            </p:cNvPr>
            <p:cNvSpPr txBox="1"/>
            <p:nvPr/>
          </p:nvSpPr>
          <p:spPr>
            <a:xfrm>
              <a:off x="7507705" y="3849567"/>
              <a:ext cx="2027601" cy="35619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64A532D2-0AA5-4E3C-B551-CECB29185C8F}"/>
                </a:ext>
              </a:extLst>
            </p:cNvPr>
            <p:cNvSpPr/>
            <p:nvPr/>
          </p:nvSpPr>
          <p:spPr>
            <a:xfrm>
              <a:off x="5937271" y="3836426"/>
              <a:ext cx="79380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c-Cas3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1A9115A5-ACF9-4C7A-AAF2-C7A4AE4E825B}"/>
              </a:ext>
            </a:extLst>
          </p:cNvPr>
          <p:cNvGrpSpPr/>
          <p:nvPr/>
        </p:nvGrpSpPr>
        <p:grpSpPr>
          <a:xfrm>
            <a:off x="5899266" y="4589694"/>
            <a:ext cx="4941472" cy="658003"/>
            <a:chOff x="5899266" y="4589694"/>
            <a:chExt cx="4941472" cy="658003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23B9C455-20AE-4550-AE93-BD7C2D8C8E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38000" contrast="49000"/>
                      </a14:imgEffect>
                    </a14:imgLayer>
                  </a14:imgProps>
                </a:ext>
              </a:extLst>
            </a:blip>
            <a:srcRect l="10846" t="16888" r="6065"/>
            <a:stretch/>
          </p:blipFill>
          <p:spPr>
            <a:xfrm>
              <a:off x="6679545" y="4589694"/>
              <a:ext cx="4161193" cy="658003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BE703EC-F84F-40BC-BAAC-9286BAE395D4}"/>
                </a:ext>
              </a:extLst>
            </p:cNvPr>
            <p:cNvSpPr txBox="1"/>
            <p:nvPr/>
          </p:nvSpPr>
          <p:spPr>
            <a:xfrm>
              <a:off x="7339263" y="4707567"/>
              <a:ext cx="2250065" cy="3864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C8666A5-CD59-44E3-9A13-56F446F9C68D}"/>
                </a:ext>
              </a:extLst>
            </p:cNvPr>
            <p:cNvSpPr txBox="1"/>
            <p:nvPr/>
          </p:nvSpPr>
          <p:spPr>
            <a:xfrm>
              <a:off x="5899266" y="4693699"/>
              <a:ext cx="1426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Calibri" panose="020F0502020204030204" pitchFamily="34" charset="0"/>
                  <a:ea typeface="Lucida Grande"/>
                  <a:cs typeface="Calibri" panose="020F0502020204030204" pitchFamily="34" charset="0"/>
                </a:rPr>
                <a:t>β</a:t>
              </a:r>
              <a:r>
                <a:rPr 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6AF4BE2B-6B14-4ABF-9057-CF6B89DB486F}"/>
              </a:ext>
            </a:extLst>
          </p:cNvPr>
          <p:cNvSpPr txBox="1"/>
          <p:nvPr/>
        </p:nvSpPr>
        <p:spPr>
          <a:xfrm>
            <a:off x="5968702" y="440062"/>
            <a:ext cx="125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D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48673E5-9D85-404B-B101-FEBA4A34B07D}"/>
              </a:ext>
            </a:extLst>
          </p:cNvPr>
          <p:cNvSpPr/>
          <p:nvPr/>
        </p:nvSpPr>
        <p:spPr>
          <a:xfrm>
            <a:off x="261075" y="35386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7271668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9BE2581-D655-4F4B-9A20-F4FD9DD9E999}"/>
              </a:ext>
            </a:extLst>
          </p:cNvPr>
          <p:cNvSpPr txBox="1"/>
          <p:nvPr/>
        </p:nvSpPr>
        <p:spPr>
          <a:xfrm>
            <a:off x="6123284" y="451548"/>
            <a:ext cx="2176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F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E2EF65B5-A9EA-4430-B496-E339DEF11832}"/>
              </a:ext>
            </a:extLst>
          </p:cNvPr>
          <p:cNvGrpSpPr/>
          <p:nvPr/>
        </p:nvGrpSpPr>
        <p:grpSpPr>
          <a:xfrm>
            <a:off x="6508327" y="1036508"/>
            <a:ext cx="4863842" cy="3834233"/>
            <a:chOff x="1143572" y="714946"/>
            <a:chExt cx="4863842" cy="3834233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8815BA0C-1141-48D3-8D21-66BD167CED15}"/>
                </a:ext>
              </a:extLst>
            </p:cNvPr>
            <p:cNvGrpSpPr/>
            <p:nvPr/>
          </p:nvGrpSpPr>
          <p:grpSpPr>
            <a:xfrm>
              <a:off x="1143572" y="714946"/>
              <a:ext cx="4863842" cy="1971675"/>
              <a:chOff x="1143572" y="714946"/>
              <a:chExt cx="4863842" cy="1971675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9E652F5B-E754-45E9-A0C4-AD82B6F23937}"/>
                  </a:ext>
                </a:extLst>
              </p:cNvPr>
              <p:cNvGrpSpPr/>
              <p:nvPr/>
            </p:nvGrpSpPr>
            <p:grpSpPr>
              <a:xfrm>
                <a:off x="1521139" y="714946"/>
                <a:ext cx="4486275" cy="1971675"/>
                <a:chOff x="1521139" y="714946"/>
                <a:chExt cx="4486275" cy="1971675"/>
              </a:xfrm>
            </p:grpSpPr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E221EE20-7EFF-4608-BD50-E76184FFF4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21139" y="714946"/>
                  <a:ext cx="4486275" cy="1971675"/>
                </a:xfrm>
                <a:prstGeom prst="rect">
                  <a:avLst/>
                </a:prstGeom>
              </p:spPr>
            </p:pic>
            <p:sp>
              <p:nvSpPr>
                <p:cNvPr id="6" name="Rectangle 5">
                  <a:extLst>
                    <a:ext uri="{FF2B5EF4-FFF2-40B4-BE49-F238E27FC236}">
                      <a16:creationId xmlns:a16="http://schemas.microsoft.com/office/drawing/2014/main" id="{82942A81-40D6-41C2-8881-661F28CE792E}"/>
                    </a:ext>
                  </a:extLst>
                </p:cNvPr>
                <p:cNvSpPr/>
                <p:nvPr/>
              </p:nvSpPr>
              <p:spPr>
                <a:xfrm>
                  <a:off x="1926432" y="877824"/>
                  <a:ext cx="2837592" cy="36933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4AAAA15F-E0E9-4C3E-B4BE-3439CA3BBC47}"/>
                    </a:ext>
                  </a:extLst>
                </p:cNvPr>
                <p:cNvSpPr/>
                <p:nvPr/>
              </p:nvSpPr>
              <p:spPr>
                <a:xfrm>
                  <a:off x="1963008" y="2116912"/>
                  <a:ext cx="2837592" cy="42528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C35980D-236A-4CEE-9B5E-E3EB061B4471}"/>
                  </a:ext>
                </a:extLst>
              </p:cNvPr>
              <p:cNvSpPr txBox="1"/>
              <p:nvPr/>
            </p:nvSpPr>
            <p:spPr>
              <a:xfrm>
                <a:off x="1143572" y="824025"/>
                <a:ext cx="14260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Calibri" panose="020F0502020204030204" pitchFamily="34" charset="0"/>
                    <a:ea typeface="Lucida Grande"/>
                    <a:cs typeface="Calibri" panose="020F0502020204030204" pitchFamily="34" charset="0"/>
                  </a:rPr>
                  <a:t>β</a:t>
                </a:r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-actin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E57FA12-29FB-4AE1-94BC-027E84BABD8B}"/>
                  </a:ext>
                </a:extLst>
              </p:cNvPr>
              <p:cNvSpPr txBox="1"/>
              <p:nvPr/>
            </p:nvSpPr>
            <p:spPr>
              <a:xfrm>
                <a:off x="1244008" y="2112249"/>
                <a:ext cx="18928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-Cas3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01D8BD3D-158C-4031-A63F-6BEE5AB52B87}"/>
                </a:ext>
              </a:extLst>
            </p:cNvPr>
            <p:cNvGrpSpPr/>
            <p:nvPr/>
          </p:nvGrpSpPr>
          <p:grpSpPr>
            <a:xfrm>
              <a:off x="1407076" y="2864162"/>
              <a:ext cx="4486274" cy="1095572"/>
              <a:chOff x="1454465" y="3205506"/>
              <a:chExt cx="4486274" cy="1095572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EF1D6F9C-3C32-47B8-BA40-91394302EF63}"/>
                  </a:ext>
                </a:extLst>
              </p:cNvPr>
              <p:cNvGrpSpPr/>
              <p:nvPr/>
            </p:nvGrpSpPr>
            <p:grpSpPr>
              <a:xfrm>
                <a:off x="1454465" y="3205506"/>
                <a:ext cx="4486274" cy="1095572"/>
                <a:chOff x="1454465" y="3205506"/>
                <a:chExt cx="4486274" cy="1095572"/>
              </a:xfrm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6FF8D335-880A-470C-8865-87646D8062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rcRect t="33833"/>
                <a:stretch/>
              </p:blipFill>
              <p:spPr>
                <a:xfrm flipH="1">
                  <a:off x="1454465" y="3205506"/>
                  <a:ext cx="4486274" cy="1095572"/>
                </a:xfrm>
                <a:prstGeom prst="rect">
                  <a:avLst/>
                </a:prstGeom>
              </p:spPr>
            </p:pic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id="{3C37E01F-71FC-411C-A021-C538D5015A57}"/>
                    </a:ext>
                  </a:extLst>
                </p:cNvPr>
                <p:cNvSpPr/>
                <p:nvPr/>
              </p:nvSpPr>
              <p:spPr>
                <a:xfrm>
                  <a:off x="2010398" y="3571056"/>
                  <a:ext cx="2837592" cy="48191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066D166-0709-432A-8E58-3E3A1A375787}"/>
                  </a:ext>
                </a:extLst>
              </p:cNvPr>
              <p:cNvSpPr txBox="1"/>
              <p:nvPr/>
            </p:nvSpPr>
            <p:spPr>
              <a:xfrm>
                <a:off x="1454465" y="3627346"/>
                <a:ext cx="67665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AKT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301E410A-7FE9-43A2-BFA7-48BD9BA2D3A6}"/>
                </a:ext>
              </a:extLst>
            </p:cNvPr>
            <p:cNvGrpSpPr/>
            <p:nvPr/>
          </p:nvGrpSpPr>
          <p:grpSpPr>
            <a:xfrm>
              <a:off x="1244008" y="4088587"/>
              <a:ext cx="4667014" cy="460592"/>
              <a:chOff x="1407076" y="4631658"/>
              <a:chExt cx="4667014" cy="460592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60D61F57-64C7-480D-89B5-8DFD2D843D00}"/>
                  </a:ext>
                </a:extLst>
              </p:cNvPr>
              <p:cNvGrpSpPr/>
              <p:nvPr/>
            </p:nvGrpSpPr>
            <p:grpSpPr>
              <a:xfrm>
                <a:off x="1454465" y="4631658"/>
                <a:ext cx="4619625" cy="406686"/>
                <a:chOff x="1454465" y="4631658"/>
                <a:chExt cx="4619625" cy="369332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6EA9744B-A05D-4C9B-A4A5-C773664F8B6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 flipH="1">
                  <a:off x="1454465" y="4631658"/>
                  <a:ext cx="4619625" cy="369332"/>
                </a:xfrm>
                <a:prstGeom prst="rect">
                  <a:avLst/>
                </a:prstGeom>
              </p:spPr>
            </p:pic>
            <p:sp>
              <p:nvSpPr>
                <p:cNvPr id="11" name="Rectangle 10">
                  <a:extLst>
                    <a:ext uri="{FF2B5EF4-FFF2-40B4-BE49-F238E27FC236}">
                      <a16:creationId xmlns:a16="http://schemas.microsoft.com/office/drawing/2014/main" id="{B60C4E42-7097-419B-B853-CD3070F6BB15}"/>
                    </a:ext>
                  </a:extLst>
                </p:cNvPr>
                <p:cNvSpPr/>
                <p:nvPr/>
              </p:nvSpPr>
              <p:spPr>
                <a:xfrm>
                  <a:off x="2190412" y="4650161"/>
                  <a:ext cx="2773256" cy="35082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3742825-3B26-44DC-A001-762785BEEBBD}"/>
                  </a:ext>
                </a:extLst>
              </p:cNvPr>
              <p:cNvSpPr txBox="1"/>
              <p:nvPr/>
            </p:nvSpPr>
            <p:spPr>
              <a:xfrm>
                <a:off x="1407076" y="4722918"/>
                <a:ext cx="12070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p-AKT</a:t>
                </a:r>
              </a:p>
            </p:txBody>
          </p:sp>
        </p:grp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ACAC9CCB-5BF7-42F7-9578-0655D047D8C4}"/>
              </a:ext>
            </a:extLst>
          </p:cNvPr>
          <p:cNvGrpSpPr/>
          <p:nvPr/>
        </p:nvGrpSpPr>
        <p:grpSpPr>
          <a:xfrm>
            <a:off x="752545" y="1831137"/>
            <a:ext cx="4648434" cy="960342"/>
            <a:chOff x="752545" y="1831137"/>
            <a:chExt cx="4648434" cy="960342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1499FE79-4A20-4A21-9B72-BF065FB01E73}"/>
                </a:ext>
              </a:extLst>
            </p:cNvPr>
            <p:cNvGrpSpPr/>
            <p:nvPr/>
          </p:nvGrpSpPr>
          <p:grpSpPr>
            <a:xfrm>
              <a:off x="964069" y="1897741"/>
              <a:ext cx="4436910" cy="893738"/>
              <a:chOff x="1760194" y="3165961"/>
              <a:chExt cx="4436910" cy="893738"/>
            </a:xfrm>
          </p:grpSpPr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C4C4104F-CDC6-48A8-8DE9-EBEF74D90F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760194" y="3165961"/>
                <a:ext cx="4436910" cy="893738"/>
              </a:xfrm>
              <a:prstGeom prst="rect">
                <a:avLst/>
              </a:prstGeom>
            </p:spPr>
          </p:pic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A83B2B19-A46A-468E-8799-2B963DF3911C}"/>
                  </a:ext>
                </a:extLst>
              </p:cNvPr>
              <p:cNvSpPr txBox="1"/>
              <p:nvPr/>
            </p:nvSpPr>
            <p:spPr>
              <a:xfrm>
                <a:off x="2324698" y="3428730"/>
                <a:ext cx="2850805" cy="43003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02AEE2D-E511-4B7E-9B67-3740DD686825}"/>
                </a:ext>
              </a:extLst>
            </p:cNvPr>
            <p:cNvSpPr txBox="1"/>
            <p:nvPr/>
          </p:nvSpPr>
          <p:spPr>
            <a:xfrm>
              <a:off x="752545" y="1831137"/>
              <a:ext cx="9875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-Cas3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32EC7DAB-84A3-47CB-869F-F5D3E77F961A}"/>
              </a:ext>
            </a:extLst>
          </p:cNvPr>
          <p:cNvGrpSpPr/>
          <p:nvPr/>
        </p:nvGrpSpPr>
        <p:grpSpPr>
          <a:xfrm>
            <a:off x="812210" y="3120852"/>
            <a:ext cx="4280333" cy="614241"/>
            <a:chOff x="812210" y="3120852"/>
            <a:chExt cx="4280333" cy="614241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F4D3E896-D057-4E0C-BEA4-5F3EC0BA551A}"/>
                </a:ext>
              </a:extLst>
            </p:cNvPr>
            <p:cNvGrpSpPr/>
            <p:nvPr/>
          </p:nvGrpSpPr>
          <p:grpSpPr>
            <a:xfrm>
              <a:off x="1072993" y="3120852"/>
              <a:ext cx="4019550" cy="614241"/>
              <a:chOff x="1819083" y="4083877"/>
              <a:chExt cx="4019550" cy="614241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786F33BD-96CC-4B3F-9806-19839C7D6B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819083" y="4083877"/>
                <a:ext cx="4019550" cy="614241"/>
              </a:xfrm>
              <a:prstGeom prst="rect">
                <a:avLst/>
              </a:prstGeom>
            </p:spPr>
          </p:pic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39AFA94-EC5D-4B3A-AAF1-9F408B837614}"/>
                  </a:ext>
                </a:extLst>
              </p:cNvPr>
              <p:cNvSpPr txBox="1"/>
              <p:nvPr/>
            </p:nvSpPr>
            <p:spPr>
              <a:xfrm>
                <a:off x="2383587" y="4163310"/>
                <a:ext cx="2791916" cy="36933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762B1C0-969B-4A46-B444-5F9C1E25B91D}"/>
                </a:ext>
              </a:extLst>
            </p:cNvPr>
            <p:cNvSpPr txBox="1"/>
            <p:nvPr/>
          </p:nvSpPr>
          <p:spPr>
            <a:xfrm>
              <a:off x="812210" y="3270838"/>
              <a:ext cx="731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KT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4949CE1C-DCD3-4395-9AFE-58FB6E794817}"/>
              </a:ext>
            </a:extLst>
          </p:cNvPr>
          <p:cNvGrpSpPr/>
          <p:nvPr/>
        </p:nvGrpSpPr>
        <p:grpSpPr>
          <a:xfrm>
            <a:off x="577115" y="3857547"/>
            <a:ext cx="4958669" cy="614241"/>
            <a:chOff x="577115" y="3857547"/>
            <a:chExt cx="4958669" cy="614241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A7CA12FB-AC03-40A4-BF11-D112F46304A4}"/>
                </a:ext>
              </a:extLst>
            </p:cNvPr>
            <p:cNvGrpSpPr/>
            <p:nvPr/>
          </p:nvGrpSpPr>
          <p:grpSpPr>
            <a:xfrm>
              <a:off x="1017097" y="3857547"/>
              <a:ext cx="4518687" cy="614241"/>
              <a:chOff x="1794697" y="4599841"/>
              <a:chExt cx="4518687" cy="614241"/>
            </a:xfrm>
          </p:grpSpPr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EC8F3D5E-3AE7-4414-ADE2-C00F8AAE4F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flipH="1">
                <a:off x="1794697" y="4599841"/>
                <a:ext cx="4518687" cy="614241"/>
              </a:xfrm>
              <a:prstGeom prst="rect">
                <a:avLst/>
              </a:prstGeom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5B3E66FB-CF1E-40AD-A4FB-2C0C268CA04E}"/>
                  </a:ext>
                </a:extLst>
              </p:cNvPr>
              <p:cNvSpPr txBox="1"/>
              <p:nvPr/>
            </p:nvSpPr>
            <p:spPr>
              <a:xfrm>
                <a:off x="2383587" y="4722296"/>
                <a:ext cx="2791916" cy="36933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DE4846F-B63C-422F-9F1C-988E516820C5}"/>
                </a:ext>
              </a:extLst>
            </p:cNvPr>
            <p:cNvSpPr txBox="1"/>
            <p:nvPr/>
          </p:nvSpPr>
          <p:spPr>
            <a:xfrm>
              <a:off x="577115" y="3956538"/>
              <a:ext cx="1426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Calibri" panose="020F0502020204030204" pitchFamily="34" charset="0"/>
                  <a:ea typeface="Lucida Grande"/>
                  <a:cs typeface="Calibri" panose="020F0502020204030204" pitchFamily="34" charset="0"/>
                </a:rPr>
                <a:t>β</a:t>
              </a:r>
              <a:r>
                <a:rPr 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FC7212B2-D3E6-4E76-99EC-AEFF8669F396}"/>
              </a:ext>
            </a:extLst>
          </p:cNvPr>
          <p:cNvGrpSpPr/>
          <p:nvPr/>
        </p:nvGrpSpPr>
        <p:grpSpPr>
          <a:xfrm>
            <a:off x="686521" y="961471"/>
            <a:ext cx="4726443" cy="685975"/>
            <a:chOff x="686521" y="961471"/>
            <a:chExt cx="4726443" cy="685975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6589C9D6-1A87-4C09-99D6-48FA85742244}"/>
                </a:ext>
              </a:extLst>
            </p:cNvPr>
            <p:cNvGrpSpPr/>
            <p:nvPr/>
          </p:nvGrpSpPr>
          <p:grpSpPr>
            <a:xfrm>
              <a:off x="976052" y="1056109"/>
              <a:ext cx="4436912" cy="591337"/>
              <a:chOff x="1812087" y="2550446"/>
              <a:chExt cx="4204664" cy="591337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B4D417A3-45A0-4249-85F7-171E8B4B8D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flipH="1">
                <a:off x="1812087" y="2550446"/>
                <a:ext cx="4204664" cy="591337"/>
              </a:xfrm>
              <a:prstGeom prst="rect">
                <a:avLst/>
              </a:prstGeom>
            </p:spPr>
          </p:pic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21681824-AB44-49D6-8AE8-C85BCF5AC38B}"/>
                  </a:ext>
                </a:extLst>
              </p:cNvPr>
              <p:cNvSpPr txBox="1"/>
              <p:nvPr/>
            </p:nvSpPr>
            <p:spPr>
              <a:xfrm>
                <a:off x="2385792" y="2641159"/>
                <a:ext cx="2701582" cy="36933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72A6931-C281-4F04-93A9-01E9613E8B0C}"/>
                </a:ext>
              </a:extLst>
            </p:cNvPr>
            <p:cNvSpPr txBox="1"/>
            <p:nvPr/>
          </p:nvSpPr>
          <p:spPr>
            <a:xfrm>
              <a:off x="686521" y="961471"/>
              <a:ext cx="9509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AKT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E38BF927-AE17-425C-B104-583ADB7C1092}"/>
              </a:ext>
            </a:extLst>
          </p:cNvPr>
          <p:cNvSpPr txBox="1"/>
          <p:nvPr/>
        </p:nvSpPr>
        <p:spPr>
          <a:xfrm>
            <a:off x="381721" y="406595"/>
            <a:ext cx="2176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E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66EDCAE-993B-4F06-9514-9A2E6E8CFE51}"/>
              </a:ext>
            </a:extLst>
          </p:cNvPr>
          <p:cNvSpPr/>
          <p:nvPr/>
        </p:nvSpPr>
        <p:spPr>
          <a:xfrm>
            <a:off x="105483" y="16516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2888109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2ED4632-211C-4560-9B81-AC8F951968BC}"/>
              </a:ext>
            </a:extLst>
          </p:cNvPr>
          <p:cNvSpPr txBox="1"/>
          <p:nvPr/>
        </p:nvSpPr>
        <p:spPr>
          <a:xfrm>
            <a:off x="579338" y="345292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G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FBCB0BB4-478E-4288-B34F-4E2AC564D5D7}"/>
              </a:ext>
            </a:extLst>
          </p:cNvPr>
          <p:cNvGrpSpPr/>
          <p:nvPr/>
        </p:nvGrpSpPr>
        <p:grpSpPr>
          <a:xfrm>
            <a:off x="749808" y="1083496"/>
            <a:ext cx="5273820" cy="3257941"/>
            <a:chOff x="749808" y="1083496"/>
            <a:chExt cx="5273820" cy="3257941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352FB38A-331D-46CD-964D-ACC7FE77D0E7}"/>
                </a:ext>
              </a:extLst>
            </p:cNvPr>
            <p:cNvGrpSpPr/>
            <p:nvPr/>
          </p:nvGrpSpPr>
          <p:grpSpPr>
            <a:xfrm>
              <a:off x="858539" y="1083496"/>
              <a:ext cx="5165089" cy="1397204"/>
              <a:chOff x="858539" y="1083496"/>
              <a:chExt cx="5165089" cy="1397204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0DFD3796-29D3-412F-B221-5795DF112884}"/>
                  </a:ext>
                </a:extLst>
              </p:cNvPr>
              <p:cNvGrpSpPr/>
              <p:nvPr/>
            </p:nvGrpSpPr>
            <p:grpSpPr>
              <a:xfrm>
                <a:off x="1443213" y="1083496"/>
                <a:ext cx="4580415" cy="1397204"/>
                <a:chOff x="4367460" y="924892"/>
                <a:chExt cx="4580415" cy="1397204"/>
              </a:xfrm>
            </p:grpSpPr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CE0379CF-F621-47ED-B8CC-A5C055151B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rcRect l="7440" r="45178" b="19921"/>
                <a:stretch/>
              </p:blipFill>
              <p:spPr>
                <a:xfrm rot="10800000" flipV="1">
                  <a:off x="4367460" y="924892"/>
                  <a:ext cx="4580415" cy="1397204"/>
                </a:xfrm>
                <a:prstGeom prst="rect">
                  <a:avLst/>
                </a:prstGeom>
              </p:spPr>
            </p:pic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C69E576D-54A5-4419-9BDA-C20A874F80B5}"/>
                    </a:ext>
                  </a:extLst>
                </p:cNvPr>
                <p:cNvSpPr txBox="1"/>
                <p:nvPr/>
              </p:nvSpPr>
              <p:spPr>
                <a:xfrm>
                  <a:off x="4809693" y="1455969"/>
                  <a:ext cx="3666983" cy="40907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4448FD9-918C-44A5-9937-9E8078CFB8B5}"/>
                  </a:ext>
                </a:extLst>
              </p:cNvPr>
              <p:cNvSpPr txBox="1"/>
              <p:nvPr/>
            </p:nvSpPr>
            <p:spPr>
              <a:xfrm>
                <a:off x="858539" y="1552403"/>
                <a:ext cx="5557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/>
                  <a:t>Bim</a:t>
                </a:r>
                <a:endParaRPr lang="en-US" dirty="0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2027503E-6093-4D7C-97A8-9977CBBC2856}"/>
                </a:ext>
              </a:extLst>
            </p:cNvPr>
            <p:cNvGrpSpPr/>
            <p:nvPr/>
          </p:nvGrpSpPr>
          <p:grpSpPr>
            <a:xfrm>
              <a:off x="753798" y="2441526"/>
              <a:ext cx="5269830" cy="987474"/>
              <a:chOff x="753798" y="2441526"/>
              <a:chExt cx="5269830" cy="987474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E31D1E1B-BBF5-4116-BC2D-CB578A66FD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rcRect l="59937" t="2646" r="5350"/>
              <a:stretch/>
            </p:blipFill>
            <p:spPr>
              <a:xfrm>
                <a:off x="1443213" y="2441526"/>
                <a:ext cx="4580415" cy="987474"/>
              </a:xfrm>
              <a:prstGeom prst="rect">
                <a:avLst/>
              </a:prstGeom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8D660A45-0276-4548-90B2-34B8D72F4688}"/>
                  </a:ext>
                </a:extLst>
              </p:cNvPr>
              <p:cNvSpPr txBox="1"/>
              <p:nvPr/>
            </p:nvSpPr>
            <p:spPr>
              <a:xfrm>
                <a:off x="1876925" y="2637697"/>
                <a:ext cx="3694246" cy="62495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3B520D6-9908-4CB7-9732-385E097DD810}"/>
                  </a:ext>
                </a:extLst>
              </p:cNvPr>
              <p:cNvSpPr txBox="1"/>
              <p:nvPr/>
            </p:nvSpPr>
            <p:spPr>
              <a:xfrm>
                <a:off x="753798" y="2760825"/>
                <a:ext cx="87830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-Cas3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FAFD719A-BBC4-4861-95A2-CE058CB22BC5}"/>
                </a:ext>
              </a:extLst>
            </p:cNvPr>
            <p:cNvGrpSpPr/>
            <p:nvPr/>
          </p:nvGrpSpPr>
          <p:grpSpPr>
            <a:xfrm>
              <a:off x="749808" y="3512762"/>
              <a:ext cx="5273818" cy="828675"/>
              <a:chOff x="749808" y="3512762"/>
              <a:chExt cx="5273818" cy="828675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0496B7A-1F48-406D-BC3B-E9F81BEB61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45864" t="-3515" r="3995"/>
              <a:stretch/>
            </p:blipFill>
            <p:spPr>
              <a:xfrm flipH="1">
                <a:off x="1443211" y="3512762"/>
                <a:ext cx="4580415" cy="828675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4534C0CB-FE4B-49B0-BAA4-AC9A52A60F6E}"/>
                  </a:ext>
                </a:extLst>
              </p:cNvPr>
              <p:cNvSpPr txBox="1"/>
              <p:nvPr/>
            </p:nvSpPr>
            <p:spPr>
              <a:xfrm>
                <a:off x="1895668" y="3626489"/>
                <a:ext cx="3675503" cy="62495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70B6C1D-5BC3-487D-BF70-972AB1F3B2A3}"/>
                  </a:ext>
                </a:extLst>
              </p:cNvPr>
              <p:cNvSpPr txBox="1"/>
              <p:nvPr/>
            </p:nvSpPr>
            <p:spPr>
              <a:xfrm>
                <a:off x="749808" y="3723119"/>
                <a:ext cx="14260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Calibri" panose="020F0502020204030204" pitchFamily="34" charset="0"/>
                    <a:ea typeface="Lucida Grande"/>
                    <a:cs typeface="Calibri" panose="020F0502020204030204" pitchFamily="34" charset="0"/>
                  </a:rPr>
                  <a:t>β</a:t>
                </a:r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-actin</a:t>
                </a:r>
              </a:p>
            </p:txBody>
          </p:sp>
        </p:grp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D8635DB7-3834-4396-8225-3288F78427E7}"/>
              </a:ext>
            </a:extLst>
          </p:cNvPr>
          <p:cNvGrpSpPr/>
          <p:nvPr/>
        </p:nvGrpSpPr>
        <p:grpSpPr>
          <a:xfrm>
            <a:off x="6399066" y="1138683"/>
            <a:ext cx="4696462" cy="3297604"/>
            <a:chOff x="6399066" y="1138683"/>
            <a:chExt cx="4696462" cy="3297604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AD2EA2B6-A9FD-4682-953B-7CA4F64AB4F0}"/>
                </a:ext>
              </a:extLst>
            </p:cNvPr>
            <p:cNvGrpSpPr/>
            <p:nvPr/>
          </p:nvGrpSpPr>
          <p:grpSpPr>
            <a:xfrm>
              <a:off x="6399066" y="3655830"/>
              <a:ext cx="4696462" cy="780457"/>
              <a:chOff x="6399066" y="3655830"/>
              <a:chExt cx="4696462" cy="780457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939705DC-86E5-4109-AFC6-65AB21134A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4423" t="5819" r="19763"/>
              <a:stretch/>
            </p:blipFill>
            <p:spPr>
              <a:xfrm>
                <a:off x="6889268" y="3655830"/>
                <a:ext cx="4206260" cy="780457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485133C-3452-4F89-A4E4-8A633E786A47}"/>
                  </a:ext>
                </a:extLst>
              </p:cNvPr>
              <p:cNvSpPr txBox="1"/>
              <p:nvPr/>
            </p:nvSpPr>
            <p:spPr>
              <a:xfrm>
                <a:off x="7234395" y="3871611"/>
                <a:ext cx="3666983" cy="4090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5A1EF9C8-8859-429E-8F60-3C2177771611}"/>
                  </a:ext>
                </a:extLst>
              </p:cNvPr>
              <p:cNvSpPr txBox="1"/>
              <p:nvPr/>
            </p:nvSpPr>
            <p:spPr>
              <a:xfrm>
                <a:off x="6399066" y="3872880"/>
                <a:ext cx="14260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Calibri" panose="020F0502020204030204" pitchFamily="34" charset="0"/>
                    <a:ea typeface="Lucida Grande"/>
                    <a:cs typeface="Calibri" panose="020F0502020204030204" pitchFamily="34" charset="0"/>
                  </a:rPr>
                  <a:t>β</a:t>
                </a:r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-actin</a:t>
                </a:r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B9B492D8-293D-4569-B4C5-BD2A57E42016}"/>
                </a:ext>
              </a:extLst>
            </p:cNvPr>
            <p:cNvGrpSpPr/>
            <p:nvPr/>
          </p:nvGrpSpPr>
          <p:grpSpPr>
            <a:xfrm>
              <a:off x="6486444" y="2507116"/>
              <a:ext cx="4609083" cy="1148714"/>
              <a:chOff x="6486444" y="2507116"/>
              <a:chExt cx="4609083" cy="1148714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E04DE2EA-6EF5-4921-B053-CA51A1BC6E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53243" r="-1960"/>
              <a:stretch/>
            </p:blipFill>
            <p:spPr>
              <a:xfrm flipH="1">
                <a:off x="6713041" y="2507116"/>
                <a:ext cx="4382486" cy="1148714"/>
              </a:xfrm>
              <a:prstGeom prst="rect">
                <a:avLst/>
              </a:prstGeom>
            </p:spPr>
          </p:pic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07DA12C5-E7EE-4CFD-8C95-D9421A53BA8B}"/>
                  </a:ext>
                </a:extLst>
              </p:cNvPr>
              <p:cNvSpPr txBox="1"/>
              <p:nvPr/>
            </p:nvSpPr>
            <p:spPr>
              <a:xfrm>
                <a:off x="7260251" y="2631810"/>
                <a:ext cx="3666983" cy="4090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806330F-406F-4206-BE3F-6243B4B3A393}"/>
                  </a:ext>
                </a:extLst>
              </p:cNvPr>
              <p:cNvSpPr txBox="1"/>
              <p:nvPr/>
            </p:nvSpPr>
            <p:spPr>
              <a:xfrm>
                <a:off x="6486444" y="2613671"/>
                <a:ext cx="87830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-Cas3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BA04B74B-F6C5-4973-BFDF-3A507D022E0E}"/>
                </a:ext>
              </a:extLst>
            </p:cNvPr>
            <p:cNvGrpSpPr/>
            <p:nvPr/>
          </p:nvGrpSpPr>
          <p:grpSpPr>
            <a:xfrm>
              <a:off x="6435187" y="1138683"/>
              <a:ext cx="4660339" cy="1315176"/>
              <a:chOff x="6435187" y="1138683"/>
              <a:chExt cx="4660339" cy="1315176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A6FD29AE-FBBF-4D82-A851-775B7D235C8D}"/>
                  </a:ext>
                </a:extLst>
              </p:cNvPr>
              <p:cNvGrpSpPr/>
              <p:nvPr/>
            </p:nvGrpSpPr>
            <p:grpSpPr>
              <a:xfrm>
                <a:off x="6889267" y="1138683"/>
                <a:ext cx="4206259" cy="1315176"/>
                <a:chOff x="8315418" y="1608306"/>
                <a:chExt cx="4206259" cy="1315176"/>
              </a:xfrm>
            </p:grpSpPr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D6FF8D46-0D48-46F4-82FC-AFDCC4ADFB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rcRect l="52618" t="-1" r="6094" b="24623"/>
                <a:stretch/>
              </p:blipFill>
              <p:spPr>
                <a:xfrm rot="10800000" flipV="1">
                  <a:off x="8315418" y="1608306"/>
                  <a:ext cx="4206259" cy="1315176"/>
                </a:xfrm>
                <a:prstGeom prst="rect">
                  <a:avLst/>
                </a:prstGeom>
              </p:spPr>
            </p:pic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7AB54BF4-6CBB-40B1-A169-88E57B73A610}"/>
                    </a:ext>
                  </a:extLst>
                </p:cNvPr>
                <p:cNvSpPr txBox="1"/>
                <p:nvPr/>
              </p:nvSpPr>
              <p:spPr>
                <a:xfrm>
                  <a:off x="8686403" y="2098646"/>
                  <a:ext cx="3666983" cy="40907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276B99CD-A31D-4F66-AEB1-FE66E0F695AA}"/>
                  </a:ext>
                </a:extLst>
              </p:cNvPr>
              <p:cNvSpPr txBox="1"/>
              <p:nvPr/>
            </p:nvSpPr>
            <p:spPr>
              <a:xfrm>
                <a:off x="6435187" y="1536799"/>
                <a:ext cx="5557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/>
                  <a:t>Bim</a:t>
                </a:r>
                <a:endParaRPr lang="en-US" dirty="0"/>
              </a:p>
            </p:txBody>
          </p:sp>
        </p:grp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AE435642-EEFF-4260-BDA4-6EBAC2EA75BA}"/>
              </a:ext>
            </a:extLst>
          </p:cNvPr>
          <p:cNvSpPr txBox="1"/>
          <p:nvPr/>
        </p:nvSpPr>
        <p:spPr>
          <a:xfrm>
            <a:off x="6479621" y="307659"/>
            <a:ext cx="1227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H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676DB6B-0AA3-4053-942A-A7FF6D3409E1}"/>
              </a:ext>
            </a:extLst>
          </p:cNvPr>
          <p:cNvSpPr/>
          <p:nvPr/>
        </p:nvSpPr>
        <p:spPr>
          <a:xfrm>
            <a:off x="-11333" y="-23809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41655132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D507C34-3BB9-45FB-948F-1985AF55D099}"/>
              </a:ext>
            </a:extLst>
          </p:cNvPr>
          <p:cNvSpPr txBox="1"/>
          <p:nvPr/>
        </p:nvSpPr>
        <p:spPr>
          <a:xfrm>
            <a:off x="950976" y="393192"/>
            <a:ext cx="157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4A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95CAF8DF-07D9-44DA-9530-B1C15EE74C88}"/>
              </a:ext>
            </a:extLst>
          </p:cNvPr>
          <p:cNvGrpSpPr/>
          <p:nvPr/>
        </p:nvGrpSpPr>
        <p:grpSpPr>
          <a:xfrm>
            <a:off x="2092167" y="234399"/>
            <a:ext cx="3513723" cy="1435088"/>
            <a:chOff x="4863052" y="672028"/>
            <a:chExt cx="2137222" cy="905228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A4ADB5B-F575-44CD-BFC6-35E153EEF22A}"/>
                </a:ext>
              </a:extLst>
            </p:cNvPr>
            <p:cNvGrpSpPr/>
            <p:nvPr/>
          </p:nvGrpSpPr>
          <p:grpSpPr>
            <a:xfrm>
              <a:off x="4863052" y="672028"/>
              <a:ext cx="2137222" cy="905228"/>
              <a:chOff x="2462211" y="3666071"/>
              <a:chExt cx="2137222" cy="905228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E99A5C5A-1AFC-4C93-BD16-C387AEC1C3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55000"/>
                        </a14:imgEffect>
                      </a14:imgLayer>
                    </a14:imgProps>
                  </a:ext>
                </a:extLst>
              </a:blip>
              <a:srcRect l="8852" t="30421" b="12186"/>
              <a:stretch/>
            </p:blipFill>
            <p:spPr>
              <a:xfrm>
                <a:off x="2462211" y="3666071"/>
                <a:ext cx="2137222" cy="905228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DEE6A0A-D698-4E70-8E30-3C3BF8A514A2}"/>
                  </a:ext>
                </a:extLst>
              </p:cNvPr>
              <p:cNvSpPr txBox="1"/>
              <p:nvPr/>
            </p:nvSpPr>
            <p:spPr>
              <a:xfrm>
                <a:off x="3257424" y="3996978"/>
                <a:ext cx="1004187" cy="28241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47AE2FF-0F8F-4A1E-AD32-977F031184B4}"/>
                </a:ext>
              </a:extLst>
            </p:cNvPr>
            <p:cNvSpPr txBox="1"/>
            <p:nvPr/>
          </p:nvSpPr>
          <p:spPr>
            <a:xfrm>
              <a:off x="5054323" y="1007307"/>
              <a:ext cx="909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P94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E22E42D-4020-489A-8BFC-60B6BD36B91A}"/>
              </a:ext>
            </a:extLst>
          </p:cNvPr>
          <p:cNvGrpSpPr/>
          <p:nvPr/>
        </p:nvGrpSpPr>
        <p:grpSpPr>
          <a:xfrm rot="421775">
            <a:off x="2501128" y="3572532"/>
            <a:ext cx="2922093" cy="1242894"/>
            <a:chOff x="5037852" y="2566243"/>
            <a:chExt cx="1875283" cy="655533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AAA124BD-B0BC-4710-A43D-23B3E0372AB6}"/>
                </a:ext>
              </a:extLst>
            </p:cNvPr>
            <p:cNvGrpSpPr/>
            <p:nvPr/>
          </p:nvGrpSpPr>
          <p:grpSpPr>
            <a:xfrm>
              <a:off x="5326651" y="2566243"/>
              <a:ext cx="1586484" cy="655533"/>
              <a:chOff x="2866078" y="1401867"/>
              <a:chExt cx="1586484" cy="655533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C4DFC721-4BBA-46A2-8C7B-13B85D453C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61000"/>
                        </a14:imgEffect>
                      </a14:imgLayer>
                    </a14:imgProps>
                  </a:ext>
                </a:extLst>
              </a:blip>
              <a:srcRect l="12704" t="-2498" r="16577" b="1"/>
              <a:stretch/>
            </p:blipFill>
            <p:spPr>
              <a:xfrm>
                <a:off x="2866078" y="1401867"/>
                <a:ext cx="1586484" cy="655533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1D55037-9885-48C3-9102-BB13C4CB4449}"/>
                  </a:ext>
                </a:extLst>
              </p:cNvPr>
              <p:cNvSpPr txBox="1"/>
              <p:nvPr/>
            </p:nvSpPr>
            <p:spPr>
              <a:xfrm rot="21178225">
                <a:off x="3182112" y="1443299"/>
                <a:ext cx="975550" cy="40790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19FEF94-BD72-4459-99F4-B40AA55C4BC0}"/>
                </a:ext>
              </a:extLst>
            </p:cNvPr>
            <p:cNvSpPr txBox="1"/>
            <p:nvPr/>
          </p:nvSpPr>
          <p:spPr>
            <a:xfrm rot="21178225">
              <a:off x="5037852" y="2827875"/>
              <a:ext cx="6667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KT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86704DCA-9373-405A-A574-8C834ED84F84}"/>
              </a:ext>
            </a:extLst>
          </p:cNvPr>
          <p:cNvGrpSpPr/>
          <p:nvPr/>
        </p:nvGrpSpPr>
        <p:grpSpPr>
          <a:xfrm>
            <a:off x="2326605" y="2622249"/>
            <a:ext cx="3044846" cy="1008003"/>
            <a:chOff x="4951988" y="3478265"/>
            <a:chExt cx="1948159" cy="790940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871DEF17-9779-4B0A-AF1B-E0F57D580F5C}"/>
                </a:ext>
              </a:extLst>
            </p:cNvPr>
            <p:cNvGrpSpPr/>
            <p:nvPr/>
          </p:nvGrpSpPr>
          <p:grpSpPr>
            <a:xfrm>
              <a:off x="5041656" y="3478265"/>
              <a:ext cx="1858491" cy="790940"/>
              <a:chOff x="2581082" y="2321995"/>
              <a:chExt cx="1858491" cy="790940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5F02B7B4-0CBF-4422-9968-803B23480F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30000"/>
                        </a14:imgEffect>
                        <a14:imgEffect>
                          <a14:brightnessContrast bright="4000" contrast="79000"/>
                        </a14:imgEffect>
                      </a14:imgLayer>
                    </a14:imgProps>
                  </a:ext>
                </a:extLst>
              </a:blip>
              <a:srcRect t="19716" r="4006" b="15076"/>
              <a:stretch/>
            </p:blipFill>
            <p:spPr>
              <a:xfrm>
                <a:off x="2581082" y="2321995"/>
                <a:ext cx="1858491" cy="790940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279618E0-116A-4337-AAFF-AC4AE6CF5A0E}"/>
                  </a:ext>
                </a:extLst>
              </p:cNvPr>
              <p:cNvSpPr txBox="1"/>
              <p:nvPr/>
            </p:nvSpPr>
            <p:spPr>
              <a:xfrm>
                <a:off x="3212496" y="2537012"/>
                <a:ext cx="975550" cy="40790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CB61548-6168-48CC-AA1C-6EC599B4A88D}"/>
                </a:ext>
              </a:extLst>
            </p:cNvPr>
            <p:cNvSpPr txBox="1"/>
            <p:nvPr/>
          </p:nvSpPr>
          <p:spPr>
            <a:xfrm>
              <a:off x="4951988" y="3685164"/>
              <a:ext cx="9755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AKT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57D20022-A669-4606-B432-C121F990E431}"/>
              </a:ext>
            </a:extLst>
          </p:cNvPr>
          <p:cNvGrpSpPr/>
          <p:nvPr/>
        </p:nvGrpSpPr>
        <p:grpSpPr>
          <a:xfrm>
            <a:off x="1861918" y="1549881"/>
            <a:ext cx="4551544" cy="1142652"/>
            <a:chOff x="4773147" y="4488199"/>
            <a:chExt cx="2714625" cy="836063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387C8EBD-EBEF-4BB9-85D0-48DF84A845BF}"/>
                </a:ext>
              </a:extLst>
            </p:cNvPr>
            <p:cNvGrpSpPr/>
            <p:nvPr/>
          </p:nvGrpSpPr>
          <p:grpSpPr>
            <a:xfrm>
              <a:off x="4773147" y="4488199"/>
              <a:ext cx="2714625" cy="836063"/>
              <a:chOff x="2462209" y="4748151"/>
              <a:chExt cx="2714625" cy="836063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593F8493-FB2E-4039-89A1-37C7717DC7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64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62209" y="4748151"/>
                <a:ext cx="2714625" cy="836063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5638620E-4AF4-47A3-A75F-1783482E649A}"/>
                  </a:ext>
                </a:extLst>
              </p:cNvPr>
              <p:cNvSpPr txBox="1"/>
              <p:nvPr/>
            </p:nvSpPr>
            <p:spPr>
              <a:xfrm>
                <a:off x="3379279" y="5054517"/>
                <a:ext cx="975550" cy="40790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660997B-67A8-46C4-A27E-308FB2DA0992}"/>
                </a:ext>
              </a:extLst>
            </p:cNvPr>
            <p:cNvSpPr txBox="1"/>
            <p:nvPr/>
          </p:nvSpPr>
          <p:spPr>
            <a:xfrm>
              <a:off x="5128957" y="4856226"/>
              <a:ext cx="8046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IR</a:t>
              </a:r>
            </a:p>
          </p:txBody>
        </p:sp>
      </p:grpSp>
      <p:pic>
        <p:nvPicPr>
          <p:cNvPr id="34" name="Picture 33">
            <a:extLst>
              <a:ext uri="{FF2B5EF4-FFF2-40B4-BE49-F238E27FC236}">
                <a16:creationId xmlns:a16="http://schemas.microsoft.com/office/drawing/2014/main" id="{0A020F95-FB6E-449A-9E24-09B7421DDDE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83058" y="1523204"/>
            <a:ext cx="1667433" cy="403711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7251989A-1224-4E9A-BA8A-E40A32493B5F}"/>
              </a:ext>
            </a:extLst>
          </p:cNvPr>
          <p:cNvSpPr txBox="1"/>
          <p:nvPr/>
        </p:nvSpPr>
        <p:spPr>
          <a:xfrm>
            <a:off x="2505863" y="1510828"/>
            <a:ext cx="1495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GF-1R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CC293E39-C45A-44CC-8FCC-D495393DF526}"/>
              </a:ext>
            </a:extLst>
          </p:cNvPr>
          <p:cNvGrpSpPr/>
          <p:nvPr/>
        </p:nvGrpSpPr>
        <p:grpSpPr>
          <a:xfrm>
            <a:off x="2372313" y="4484854"/>
            <a:ext cx="3362155" cy="1347051"/>
            <a:chOff x="5040627" y="1766238"/>
            <a:chExt cx="2013648" cy="765191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C2EC6FFD-037C-490C-A9F6-A3F43D4EF4E2}"/>
                </a:ext>
              </a:extLst>
            </p:cNvPr>
            <p:cNvGrpSpPr/>
            <p:nvPr/>
          </p:nvGrpSpPr>
          <p:grpSpPr>
            <a:xfrm>
              <a:off x="5404124" y="1766238"/>
              <a:ext cx="1650151" cy="765191"/>
              <a:chOff x="2961418" y="575929"/>
              <a:chExt cx="1650151" cy="765191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5B20F12-B01A-4C4B-83D8-4D45361147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6000" contrast="44000"/>
                        </a14:imgEffect>
                      </a14:imgLayer>
                    </a14:imgProps>
                  </a:ext>
                </a:extLst>
              </a:blip>
              <a:srcRect l="18542" t="-418" r="13085"/>
              <a:stretch/>
            </p:blipFill>
            <p:spPr>
              <a:xfrm>
                <a:off x="2961418" y="575929"/>
                <a:ext cx="1650151" cy="765191"/>
              </a:xfrm>
              <a:prstGeom prst="rect">
                <a:avLst/>
              </a:prstGeom>
            </p:spPr>
          </p:pic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EAD26B65-FF6A-4D7B-8015-C56E12A6B697}"/>
                  </a:ext>
                </a:extLst>
              </p:cNvPr>
              <p:cNvSpPr txBox="1"/>
              <p:nvPr/>
            </p:nvSpPr>
            <p:spPr>
              <a:xfrm>
                <a:off x="3247874" y="762524"/>
                <a:ext cx="909788" cy="40790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AD3D080-9696-4990-B6C7-5DC61D0CE052}"/>
                </a:ext>
              </a:extLst>
            </p:cNvPr>
            <p:cNvSpPr txBox="1"/>
            <p:nvPr/>
          </p:nvSpPr>
          <p:spPr>
            <a:xfrm>
              <a:off x="5040627" y="2019632"/>
              <a:ext cx="1069848" cy="3772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Bim</a:t>
              </a:r>
              <a:endParaRPr lang="en-US" dirty="0"/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9B886D7B-A3FF-47C8-B961-C718968B4A33}"/>
              </a:ext>
            </a:extLst>
          </p:cNvPr>
          <p:cNvGrpSpPr/>
          <p:nvPr/>
        </p:nvGrpSpPr>
        <p:grpSpPr>
          <a:xfrm>
            <a:off x="2342025" y="5683312"/>
            <a:ext cx="3479413" cy="1148796"/>
            <a:chOff x="4906400" y="5437672"/>
            <a:chExt cx="2378625" cy="708497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4CDDE2CE-127F-4BF4-90BC-825524E7F6EF}"/>
                </a:ext>
              </a:extLst>
            </p:cNvPr>
            <p:cNvGrpSpPr/>
            <p:nvPr/>
          </p:nvGrpSpPr>
          <p:grpSpPr>
            <a:xfrm>
              <a:off x="5458969" y="5437672"/>
              <a:ext cx="1826056" cy="708497"/>
              <a:chOff x="3200401" y="5747503"/>
              <a:chExt cx="1662651" cy="708497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F6BB07FF-E1F6-4683-B9CA-03F0B1321C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 contrast="43000"/>
                        </a14:imgEffect>
                      </a14:imgLayer>
                    </a14:imgProps>
                  </a:ext>
                </a:extLst>
              </a:blip>
              <a:srcRect t="8380" b="6878"/>
              <a:stretch/>
            </p:blipFill>
            <p:spPr>
              <a:xfrm flipH="1">
                <a:off x="3200401" y="5747503"/>
                <a:ext cx="1662651" cy="708497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5636C81-21C1-4DCA-9DED-CFF99FAB56EC}"/>
                  </a:ext>
                </a:extLst>
              </p:cNvPr>
              <p:cNvSpPr txBox="1"/>
              <p:nvPr/>
            </p:nvSpPr>
            <p:spPr>
              <a:xfrm>
                <a:off x="3449383" y="5891522"/>
                <a:ext cx="905446" cy="38735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72BCB95-9426-4FC9-AD14-EAF82004AA15}"/>
                </a:ext>
              </a:extLst>
            </p:cNvPr>
            <p:cNvSpPr txBox="1"/>
            <p:nvPr/>
          </p:nvSpPr>
          <p:spPr>
            <a:xfrm>
              <a:off x="4906400" y="5662568"/>
              <a:ext cx="1426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Calibri" panose="020F0502020204030204" pitchFamily="34" charset="0"/>
                  <a:ea typeface="Lucida Grande"/>
                  <a:cs typeface="Calibri" panose="020F0502020204030204" pitchFamily="34" charset="0"/>
                </a:rPr>
                <a:t>β</a:t>
              </a:r>
              <a:r>
                <a:rPr 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CA2F70E6-E9BB-407F-8226-E7D7EE57BC81}"/>
              </a:ext>
            </a:extLst>
          </p:cNvPr>
          <p:cNvSpPr txBox="1"/>
          <p:nvPr/>
        </p:nvSpPr>
        <p:spPr>
          <a:xfrm>
            <a:off x="3399546" y="1567508"/>
            <a:ext cx="1650945" cy="3057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C139702-FDBA-458C-B715-CA33CA06C2D9}"/>
              </a:ext>
            </a:extLst>
          </p:cNvPr>
          <p:cNvSpPr/>
          <p:nvPr/>
        </p:nvSpPr>
        <p:spPr>
          <a:xfrm>
            <a:off x="144995" y="-20286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37481959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BB114D1-20D5-4E5A-A725-2A1122760B7C}"/>
              </a:ext>
            </a:extLst>
          </p:cNvPr>
          <p:cNvSpPr txBox="1"/>
          <p:nvPr/>
        </p:nvSpPr>
        <p:spPr>
          <a:xfrm>
            <a:off x="403840" y="178372"/>
            <a:ext cx="1956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5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7C127A8-5AAC-4BC9-9BFE-A33780128100}"/>
              </a:ext>
            </a:extLst>
          </p:cNvPr>
          <p:cNvSpPr txBox="1"/>
          <p:nvPr/>
        </p:nvSpPr>
        <p:spPr>
          <a:xfrm>
            <a:off x="6387269" y="148449"/>
            <a:ext cx="1319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5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51892A9-4D2E-437E-8D83-C45C7CA7E985}"/>
              </a:ext>
            </a:extLst>
          </p:cNvPr>
          <p:cNvSpPr txBox="1"/>
          <p:nvPr/>
        </p:nvSpPr>
        <p:spPr>
          <a:xfrm>
            <a:off x="544290" y="3591909"/>
            <a:ext cx="1153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5G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EB3B3DC3-6150-4978-85E9-172E0B877EF8}"/>
              </a:ext>
            </a:extLst>
          </p:cNvPr>
          <p:cNvGrpSpPr/>
          <p:nvPr/>
        </p:nvGrpSpPr>
        <p:grpSpPr>
          <a:xfrm>
            <a:off x="337177" y="691128"/>
            <a:ext cx="5494464" cy="1442646"/>
            <a:chOff x="544519" y="856193"/>
            <a:chExt cx="5494464" cy="1442646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DE5CDE76-894C-4DD4-9748-9CD2EABABBA4}"/>
                </a:ext>
              </a:extLst>
            </p:cNvPr>
            <p:cNvGrpSpPr/>
            <p:nvPr/>
          </p:nvGrpSpPr>
          <p:grpSpPr>
            <a:xfrm>
              <a:off x="1328258" y="856193"/>
              <a:ext cx="4710725" cy="1442646"/>
              <a:chOff x="1544967" y="840178"/>
              <a:chExt cx="4309229" cy="1217826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A7C6C4FF-CFBD-4BC5-9C27-B9AF80FBA0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544967" y="840178"/>
                <a:ext cx="4309229" cy="1217826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AC5CF4D3-A116-4F88-8AB8-2F92F04392AF}"/>
                  </a:ext>
                </a:extLst>
              </p:cNvPr>
              <p:cNvSpPr/>
              <p:nvPr/>
            </p:nvSpPr>
            <p:spPr>
              <a:xfrm>
                <a:off x="1950985" y="1092481"/>
                <a:ext cx="2165038" cy="75222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B71814A-CC6F-460A-8A3A-E9A86A104C49}"/>
                </a:ext>
              </a:extLst>
            </p:cNvPr>
            <p:cNvSpPr txBox="1"/>
            <p:nvPr/>
          </p:nvSpPr>
          <p:spPr>
            <a:xfrm>
              <a:off x="544519" y="1512704"/>
              <a:ext cx="11532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IGF-1R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6E8C52C5-5AD9-48E4-B664-AFBEFA1C8090}"/>
              </a:ext>
            </a:extLst>
          </p:cNvPr>
          <p:cNvGrpSpPr/>
          <p:nvPr/>
        </p:nvGrpSpPr>
        <p:grpSpPr>
          <a:xfrm>
            <a:off x="6527776" y="649585"/>
            <a:ext cx="4726619" cy="1505621"/>
            <a:chOff x="6406862" y="945532"/>
            <a:chExt cx="4726619" cy="1505621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EA845BD6-C151-420B-AB83-C0105BF1EA80}"/>
                </a:ext>
              </a:extLst>
            </p:cNvPr>
            <p:cNvGrpSpPr/>
            <p:nvPr/>
          </p:nvGrpSpPr>
          <p:grpSpPr>
            <a:xfrm>
              <a:off x="6822725" y="945532"/>
              <a:ext cx="4310756" cy="1505621"/>
              <a:chOff x="1642211" y="2455904"/>
              <a:chExt cx="3833104" cy="1034975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857AEAC8-1757-4C79-863A-5325706A32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3041275" y="1056840"/>
                <a:ext cx="1034975" cy="3833104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B2EBDD8D-4C9D-4CE0-B722-DA05D8AFA2D2}"/>
                  </a:ext>
                </a:extLst>
              </p:cNvPr>
              <p:cNvSpPr/>
              <p:nvPr/>
            </p:nvSpPr>
            <p:spPr>
              <a:xfrm>
                <a:off x="2133609" y="2690240"/>
                <a:ext cx="1861525" cy="6731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9CC1159-77C2-4EF1-A682-F1DBB0E62E04}"/>
                </a:ext>
              </a:extLst>
            </p:cNvPr>
            <p:cNvSpPr txBox="1"/>
            <p:nvPr/>
          </p:nvSpPr>
          <p:spPr>
            <a:xfrm>
              <a:off x="6406862" y="1585811"/>
              <a:ext cx="11532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IGF-1R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41DE7C62-2418-4765-AF12-BBF694EE5592}"/>
              </a:ext>
            </a:extLst>
          </p:cNvPr>
          <p:cNvGrpSpPr/>
          <p:nvPr/>
        </p:nvGrpSpPr>
        <p:grpSpPr>
          <a:xfrm>
            <a:off x="346535" y="2168426"/>
            <a:ext cx="5235083" cy="621859"/>
            <a:chOff x="585261" y="2451154"/>
            <a:chExt cx="5235083" cy="62185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AABB8AB-B7B0-454E-840F-12A6B566D39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546898" y="2451154"/>
              <a:ext cx="4273446" cy="621859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5FF7642-7B10-4591-9608-A3B1FA68A370}"/>
                </a:ext>
              </a:extLst>
            </p:cNvPr>
            <p:cNvSpPr txBox="1"/>
            <p:nvPr/>
          </p:nvSpPr>
          <p:spPr>
            <a:xfrm>
              <a:off x="1772106" y="2510326"/>
              <a:ext cx="2366757" cy="46686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69EF7C7-0E2F-49B6-8D12-86D234C97960}"/>
                </a:ext>
              </a:extLst>
            </p:cNvPr>
            <p:cNvSpPr txBox="1"/>
            <p:nvPr/>
          </p:nvSpPr>
          <p:spPr>
            <a:xfrm>
              <a:off x="585261" y="2510326"/>
              <a:ext cx="1426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Calibri" panose="020F0502020204030204" pitchFamily="34" charset="0"/>
                  <a:ea typeface="Lucida Grande"/>
                  <a:cs typeface="Calibri" panose="020F0502020204030204" pitchFamily="34" charset="0"/>
                </a:rPr>
                <a:t>β</a:t>
              </a:r>
              <a:r>
                <a:rPr 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2DB1C3A3-6D6E-4C83-9DC5-DE35C4811D48}"/>
              </a:ext>
            </a:extLst>
          </p:cNvPr>
          <p:cNvGrpSpPr/>
          <p:nvPr/>
        </p:nvGrpSpPr>
        <p:grpSpPr>
          <a:xfrm>
            <a:off x="6610384" y="2133774"/>
            <a:ext cx="4523098" cy="729531"/>
            <a:chOff x="6474284" y="2528946"/>
            <a:chExt cx="4523098" cy="72953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9743BAA-BEEC-4F48-AC52-054A03460EB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958821" y="2528946"/>
              <a:ext cx="4038561" cy="729531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4E2BA5F-2C22-499A-B920-99F5553A284B}"/>
                </a:ext>
              </a:extLst>
            </p:cNvPr>
            <p:cNvSpPr txBox="1"/>
            <p:nvPr/>
          </p:nvSpPr>
          <p:spPr>
            <a:xfrm>
              <a:off x="7375357" y="2732236"/>
              <a:ext cx="2093494" cy="382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ACDACAA-6E4E-48EB-B0D1-488545644E6B}"/>
                </a:ext>
              </a:extLst>
            </p:cNvPr>
            <p:cNvSpPr txBox="1"/>
            <p:nvPr/>
          </p:nvSpPr>
          <p:spPr>
            <a:xfrm>
              <a:off x="6474284" y="2709045"/>
              <a:ext cx="1426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Calibri" panose="020F0502020204030204" pitchFamily="34" charset="0"/>
                  <a:ea typeface="Lucida Grande"/>
                  <a:cs typeface="Calibri" panose="020F0502020204030204" pitchFamily="34" charset="0"/>
                </a:rPr>
                <a:t>β</a:t>
              </a:r>
              <a:r>
                <a:rPr 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AEF1D41-3447-4E8A-9646-63B121E05C8E}"/>
              </a:ext>
            </a:extLst>
          </p:cNvPr>
          <p:cNvGrpSpPr/>
          <p:nvPr/>
        </p:nvGrpSpPr>
        <p:grpSpPr>
          <a:xfrm>
            <a:off x="1720159" y="5434010"/>
            <a:ext cx="5791298" cy="1175039"/>
            <a:chOff x="1720159" y="5434010"/>
            <a:chExt cx="5791298" cy="1175039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62765970-83C8-4983-B60C-FBF65CD0192C}"/>
                </a:ext>
              </a:extLst>
            </p:cNvPr>
            <p:cNvGrpSpPr/>
            <p:nvPr/>
          </p:nvGrpSpPr>
          <p:grpSpPr>
            <a:xfrm>
              <a:off x="2511740" y="5434010"/>
              <a:ext cx="4999717" cy="1175039"/>
              <a:chOff x="3704410" y="5157216"/>
              <a:chExt cx="5011649" cy="1399032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D27C32EA-2976-42D6-9995-478829DE4F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31120" t="29197" b="16423"/>
              <a:stretch/>
            </p:blipFill>
            <p:spPr>
              <a:xfrm flipH="1">
                <a:off x="3704410" y="5157216"/>
                <a:ext cx="5011649" cy="1399032"/>
              </a:xfrm>
              <a:prstGeom prst="rect">
                <a:avLst/>
              </a:prstGeom>
            </p:spPr>
          </p:pic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32B0BB8B-2B00-4F52-A0FA-E707480628A0}"/>
                  </a:ext>
                </a:extLst>
              </p:cNvPr>
              <p:cNvSpPr/>
              <p:nvPr/>
            </p:nvSpPr>
            <p:spPr>
              <a:xfrm>
                <a:off x="4612244" y="5712333"/>
                <a:ext cx="830894" cy="43891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24AC5A4F-116A-4A83-81BF-97BDF899AE87}"/>
                  </a:ext>
                </a:extLst>
              </p:cNvPr>
              <p:cNvSpPr/>
              <p:nvPr/>
            </p:nvSpPr>
            <p:spPr>
              <a:xfrm>
                <a:off x="6562329" y="5623746"/>
                <a:ext cx="1575831" cy="43891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5FF33E0-0E96-440B-98F1-47F11D0EC43C}"/>
                </a:ext>
              </a:extLst>
            </p:cNvPr>
            <p:cNvSpPr txBox="1"/>
            <p:nvPr/>
          </p:nvSpPr>
          <p:spPr>
            <a:xfrm>
              <a:off x="1720159" y="5881289"/>
              <a:ext cx="1426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Calibri" panose="020F0502020204030204" pitchFamily="34" charset="0"/>
                  <a:ea typeface="Lucida Grande"/>
                  <a:cs typeface="Calibri" panose="020F0502020204030204" pitchFamily="34" charset="0"/>
                </a:rPr>
                <a:t>β</a:t>
              </a:r>
              <a:r>
                <a:rPr 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71D44563-686D-4928-801A-F96E9BE9410F}"/>
              </a:ext>
            </a:extLst>
          </p:cNvPr>
          <p:cNvGrpSpPr/>
          <p:nvPr/>
        </p:nvGrpSpPr>
        <p:grpSpPr>
          <a:xfrm>
            <a:off x="1358489" y="3704603"/>
            <a:ext cx="6883588" cy="1700989"/>
            <a:chOff x="1358489" y="3704603"/>
            <a:chExt cx="6883588" cy="1700989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753EE031-EBEE-44CB-9472-49ECE2F7DB4E}"/>
                </a:ext>
              </a:extLst>
            </p:cNvPr>
            <p:cNvGrpSpPr/>
            <p:nvPr/>
          </p:nvGrpSpPr>
          <p:grpSpPr>
            <a:xfrm>
              <a:off x="1781119" y="3704603"/>
              <a:ext cx="6460958" cy="1700989"/>
              <a:chOff x="2839151" y="1350424"/>
              <a:chExt cx="7157599" cy="2490227"/>
            </a:xfrm>
          </p:grpSpPr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8A47CD8E-319A-451A-8FD0-AC7B950CF5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rcRect l="2256" t="4208" r="7656" b="17726"/>
              <a:stretch/>
            </p:blipFill>
            <p:spPr>
              <a:xfrm>
                <a:off x="2839151" y="1350424"/>
                <a:ext cx="7157599" cy="2490227"/>
              </a:xfrm>
              <a:prstGeom prst="rect">
                <a:avLst/>
              </a:prstGeom>
            </p:spPr>
          </p:pic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AFD4ACF7-09A6-4263-8E99-F2A3B87409B6}"/>
                  </a:ext>
                </a:extLst>
              </p:cNvPr>
              <p:cNvSpPr/>
              <p:nvPr/>
            </p:nvSpPr>
            <p:spPr>
              <a:xfrm>
                <a:off x="6632450" y="2521358"/>
                <a:ext cx="1743454" cy="43891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16BF5948-D779-4804-A430-F7B02C68B238}"/>
                  </a:ext>
                </a:extLst>
              </p:cNvPr>
              <p:cNvSpPr/>
              <p:nvPr/>
            </p:nvSpPr>
            <p:spPr>
              <a:xfrm>
                <a:off x="4519057" y="2372202"/>
                <a:ext cx="996431" cy="43891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DE252CA-D07F-4373-9752-C6715B2DBC68}"/>
                </a:ext>
              </a:extLst>
            </p:cNvPr>
            <p:cNvSpPr txBox="1"/>
            <p:nvPr/>
          </p:nvSpPr>
          <p:spPr>
            <a:xfrm>
              <a:off x="1358489" y="4217879"/>
              <a:ext cx="11532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IGF-1R</a:t>
              </a:r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6EAC6771-EB67-48E7-AA3F-15D96ACF316C}"/>
              </a:ext>
            </a:extLst>
          </p:cNvPr>
          <p:cNvSpPr/>
          <p:nvPr/>
        </p:nvSpPr>
        <p:spPr>
          <a:xfrm>
            <a:off x="0" y="-74689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19176659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4139AC2-9FBA-41C2-8ECD-602D6945F73F}"/>
              </a:ext>
            </a:extLst>
          </p:cNvPr>
          <p:cNvSpPr txBox="1"/>
          <p:nvPr/>
        </p:nvSpPr>
        <p:spPr>
          <a:xfrm>
            <a:off x="532360" y="411314"/>
            <a:ext cx="1232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6A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254662AF-2842-40AD-A052-615A355627BF}"/>
              </a:ext>
            </a:extLst>
          </p:cNvPr>
          <p:cNvGrpSpPr/>
          <p:nvPr/>
        </p:nvGrpSpPr>
        <p:grpSpPr>
          <a:xfrm>
            <a:off x="1627259" y="603613"/>
            <a:ext cx="5086363" cy="675212"/>
            <a:chOff x="1627259" y="603613"/>
            <a:chExt cx="5086363" cy="675212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4B61A027-6868-48CE-906D-A2E4B77EB68D}"/>
                </a:ext>
              </a:extLst>
            </p:cNvPr>
            <p:cNvGrpSpPr/>
            <p:nvPr/>
          </p:nvGrpSpPr>
          <p:grpSpPr>
            <a:xfrm>
              <a:off x="2288998" y="603613"/>
              <a:ext cx="4424624" cy="675212"/>
              <a:chOff x="1938908" y="4028779"/>
              <a:chExt cx="3122030" cy="394038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1746F1A6-3C6C-470F-AA0E-7D771D7AAA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rcRect l="5539" t="22350" r="25843" b="20758"/>
              <a:stretch/>
            </p:blipFill>
            <p:spPr>
              <a:xfrm>
                <a:off x="1938908" y="4028779"/>
                <a:ext cx="3122030" cy="394038"/>
              </a:xfrm>
              <a:prstGeom prst="rect">
                <a:avLst/>
              </a:prstGeom>
            </p:spPr>
          </p:pic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43A92160-9662-45E2-BCA5-6BF086665882}"/>
                  </a:ext>
                </a:extLst>
              </p:cNvPr>
              <p:cNvSpPr/>
              <p:nvPr/>
            </p:nvSpPr>
            <p:spPr>
              <a:xfrm>
                <a:off x="2394971" y="4127960"/>
                <a:ext cx="2110807" cy="2830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886793F-E6A7-4A0C-8E07-FFAA9EC0414C}"/>
                </a:ext>
              </a:extLst>
            </p:cNvPr>
            <p:cNvSpPr txBox="1"/>
            <p:nvPr/>
          </p:nvSpPr>
          <p:spPr>
            <a:xfrm>
              <a:off x="1627259" y="773566"/>
              <a:ext cx="12322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P94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BDD01B2D-AB04-437D-BB88-BF12D80ADC80}"/>
              </a:ext>
            </a:extLst>
          </p:cNvPr>
          <p:cNvGrpSpPr/>
          <p:nvPr/>
        </p:nvGrpSpPr>
        <p:grpSpPr>
          <a:xfrm>
            <a:off x="1512961" y="1297405"/>
            <a:ext cx="5181185" cy="1295719"/>
            <a:chOff x="1512961" y="1297405"/>
            <a:chExt cx="5181185" cy="1295719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9005CAE4-3278-454C-8EE2-85588318E1A5}"/>
                </a:ext>
              </a:extLst>
            </p:cNvPr>
            <p:cNvGrpSpPr/>
            <p:nvPr/>
          </p:nvGrpSpPr>
          <p:grpSpPr>
            <a:xfrm>
              <a:off x="2269522" y="1297405"/>
              <a:ext cx="4424624" cy="1295719"/>
              <a:chOff x="5331555" y="4149176"/>
              <a:chExt cx="4401982" cy="1116313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0C912ABE-A7AC-46EF-B221-519743BACF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3000" contrast="4000"/>
                        </a14:imgEffect>
                      </a14:imgLayer>
                    </a14:imgProps>
                  </a:ext>
                </a:extLst>
              </a:blip>
              <a:srcRect l="2899" t="27701" r="28769" b="8813"/>
              <a:stretch/>
            </p:blipFill>
            <p:spPr>
              <a:xfrm>
                <a:off x="5331555" y="4149176"/>
                <a:ext cx="4401982" cy="1116313"/>
              </a:xfrm>
              <a:prstGeom prst="rect">
                <a:avLst/>
              </a:prstGeom>
            </p:spPr>
          </p:pic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F46D296A-700C-4C1B-81AD-5B980BE0F194}"/>
                  </a:ext>
                </a:extLst>
              </p:cNvPr>
              <p:cNvSpPr/>
              <p:nvPr/>
            </p:nvSpPr>
            <p:spPr>
              <a:xfrm>
                <a:off x="5949705" y="4677931"/>
                <a:ext cx="3055957" cy="34212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52D8C94-70D3-4B41-8E2E-2F953ECC77FC}"/>
                </a:ext>
              </a:extLst>
            </p:cNvPr>
            <p:cNvSpPr txBox="1"/>
            <p:nvPr/>
          </p:nvSpPr>
          <p:spPr>
            <a:xfrm>
              <a:off x="1512961" y="1863745"/>
              <a:ext cx="15520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IGF-1R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E6203BAE-1D73-4654-80A2-A9B857045BF6}"/>
              </a:ext>
            </a:extLst>
          </p:cNvPr>
          <p:cNvGrpSpPr/>
          <p:nvPr/>
        </p:nvGrpSpPr>
        <p:grpSpPr>
          <a:xfrm>
            <a:off x="1579133" y="2574758"/>
            <a:ext cx="5119599" cy="631062"/>
            <a:chOff x="1579133" y="2574758"/>
            <a:chExt cx="5119599" cy="631062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2056C0F0-6B7E-4637-9956-E53208B208E7}"/>
                </a:ext>
              </a:extLst>
            </p:cNvPr>
            <p:cNvGrpSpPr/>
            <p:nvPr/>
          </p:nvGrpSpPr>
          <p:grpSpPr>
            <a:xfrm>
              <a:off x="2243380" y="2574758"/>
              <a:ext cx="4455352" cy="631062"/>
              <a:chOff x="2258270" y="2719268"/>
              <a:chExt cx="4455352" cy="631062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67D1C6E9-D793-45DC-B237-C21B534C44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30000" contrast="50000"/>
                        </a14:imgEffect>
                      </a14:imgLayer>
                    </a14:imgProps>
                  </a:ext>
                </a:extLst>
              </a:blip>
              <a:srcRect t="-5042" r="20393"/>
              <a:stretch/>
            </p:blipFill>
            <p:spPr>
              <a:xfrm>
                <a:off x="2258270" y="2719268"/>
                <a:ext cx="4455352" cy="631062"/>
              </a:xfrm>
              <a:prstGeom prst="rect">
                <a:avLst/>
              </a:prstGeom>
            </p:spPr>
          </p:pic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AEFFC629-826A-4E33-A6AB-0B53F11AAA63}"/>
                  </a:ext>
                </a:extLst>
              </p:cNvPr>
              <p:cNvSpPr/>
              <p:nvPr/>
            </p:nvSpPr>
            <p:spPr>
              <a:xfrm>
                <a:off x="2949213" y="2852410"/>
                <a:ext cx="3021365" cy="47125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0B02C18-1C1A-45D0-92FE-E37961E6A0B7}"/>
                </a:ext>
              </a:extLst>
            </p:cNvPr>
            <p:cNvSpPr txBox="1"/>
            <p:nvPr/>
          </p:nvSpPr>
          <p:spPr>
            <a:xfrm>
              <a:off x="1579133" y="2645239"/>
              <a:ext cx="9588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AKT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C1AAEA1B-9F9E-48AA-9CDE-EF2F1EDB17AE}"/>
              </a:ext>
            </a:extLst>
          </p:cNvPr>
          <p:cNvGrpSpPr/>
          <p:nvPr/>
        </p:nvGrpSpPr>
        <p:grpSpPr>
          <a:xfrm>
            <a:off x="1764603" y="3213622"/>
            <a:ext cx="4968495" cy="865671"/>
            <a:chOff x="1764603" y="3213622"/>
            <a:chExt cx="4968495" cy="865671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A321ED8E-F73A-4FB4-B1F6-76D7329AF6E4}"/>
                </a:ext>
              </a:extLst>
            </p:cNvPr>
            <p:cNvGrpSpPr/>
            <p:nvPr/>
          </p:nvGrpSpPr>
          <p:grpSpPr>
            <a:xfrm>
              <a:off x="2269522" y="3213622"/>
              <a:ext cx="4463576" cy="865671"/>
              <a:chOff x="2250046" y="3429000"/>
              <a:chExt cx="4463576" cy="865671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2B675C17-8922-4A58-8DB3-500C6CCD0D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</a:extLst>
              </a:blip>
              <a:srcRect l="7081" t="281" r="27970" b="14344"/>
              <a:stretch/>
            </p:blipFill>
            <p:spPr>
              <a:xfrm>
                <a:off x="2250046" y="3429000"/>
                <a:ext cx="4463576" cy="865671"/>
              </a:xfrm>
              <a:prstGeom prst="rect">
                <a:avLst/>
              </a:prstGeom>
            </p:spPr>
          </p:pic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0E31622F-4D34-491E-985B-2E4A47E5E4ED}"/>
                  </a:ext>
                </a:extLst>
              </p:cNvPr>
              <p:cNvSpPr/>
              <p:nvPr/>
            </p:nvSpPr>
            <p:spPr>
              <a:xfrm>
                <a:off x="2883929" y="3661268"/>
                <a:ext cx="3118012" cy="47125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801CE32-613A-46F5-900F-47A1B94EE321}"/>
                </a:ext>
              </a:extLst>
            </p:cNvPr>
            <p:cNvSpPr txBox="1"/>
            <p:nvPr/>
          </p:nvSpPr>
          <p:spPr>
            <a:xfrm>
              <a:off x="1764603" y="3440617"/>
              <a:ext cx="8542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KT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0B292FB4-E48D-43E0-9DC0-97F526C8FF46}"/>
              </a:ext>
            </a:extLst>
          </p:cNvPr>
          <p:cNvGrpSpPr/>
          <p:nvPr/>
        </p:nvGrpSpPr>
        <p:grpSpPr>
          <a:xfrm>
            <a:off x="1764603" y="4095451"/>
            <a:ext cx="5004590" cy="981225"/>
            <a:chOff x="1764603" y="4095451"/>
            <a:chExt cx="5004590" cy="981225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464AD546-A45A-4228-9D6F-66A16F2778F5}"/>
                </a:ext>
              </a:extLst>
            </p:cNvPr>
            <p:cNvGrpSpPr/>
            <p:nvPr/>
          </p:nvGrpSpPr>
          <p:grpSpPr>
            <a:xfrm>
              <a:off x="2269522" y="4095451"/>
              <a:ext cx="4499671" cy="981225"/>
              <a:chOff x="2213951" y="4495322"/>
              <a:chExt cx="4499671" cy="981225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8121A180-54D4-485C-B94F-B6E6DE6D24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30000" contrast="30000"/>
                        </a14:imgEffect>
                      </a14:imgLayer>
                    </a14:imgProps>
                  </a:ext>
                </a:extLst>
              </a:blip>
              <a:srcRect r="23046"/>
              <a:stretch/>
            </p:blipFill>
            <p:spPr>
              <a:xfrm>
                <a:off x="2213951" y="4495322"/>
                <a:ext cx="4499671" cy="981225"/>
              </a:xfrm>
              <a:prstGeom prst="rect">
                <a:avLst/>
              </a:prstGeom>
            </p:spPr>
          </p:pic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AD820F45-8F95-488D-8C8C-C33BA951005B}"/>
                  </a:ext>
                </a:extLst>
              </p:cNvPr>
              <p:cNvSpPr/>
              <p:nvPr/>
            </p:nvSpPr>
            <p:spPr>
              <a:xfrm>
                <a:off x="2883930" y="4748635"/>
                <a:ext cx="3133000" cy="36098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E8F69E7-70D4-4046-A9D2-B38250B63B77}"/>
                </a:ext>
              </a:extLst>
            </p:cNvPr>
            <p:cNvSpPr txBox="1"/>
            <p:nvPr/>
          </p:nvSpPr>
          <p:spPr>
            <a:xfrm>
              <a:off x="1764603" y="4232205"/>
              <a:ext cx="8542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Bim</a:t>
              </a:r>
              <a:endParaRPr lang="en-US" dirty="0"/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1B1A4763-6C9A-4B3C-91BC-0019A0F5E166}"/>
              </a:ext>
            </a:extLst>
          </p:cNvPr>
          <p:cNvGrpSpPr/>
          <p:nvPr/>
        </p:nvGrpSpPr>
        <p:grpSpPr>
          <a:xfrm>
            <a:off x="1549057" y="5074036"/>
            <a:ext cx="5164565" cy="577788"/>
            <a:chOff x="1549057" y="5074036"/>
            <a:chExt cx="5164565" cy="577788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E1B08194-BF17-424A-84EB-652E8965CD06}"/>
                </a:ext>
              </a:extLst>
            </p:cNvPr>
            <p:cNvGrpSpPr/>
            <p:nvPr/>
          </p:nvGrpSpPr>
          <p:grpSpPr>
            <a:xfrm>
              <a:off x="2250045" y="5074036"/>
              <a:ext cx="4463577" cy="577788"/>
              <a:chOff x="1759880" y="5564806"/>
              <a:chExt cx="3280114" cy="459978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4CF5BA92-45FA-4DE4-9917-4169F6D210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-635" t="2872" r="27830" b="3363"/>
              <a:stretch/>
            </p:blipFill>
            <p:spPr>
              <a:xfrm>
                <a:off x="1759880" y="5571017"/>
                <a:ext cx="3280114" cy="453767"/>
              </a:xfrm>
              <a:prstGeom prst="rect">
                <a:avLst/>
              </a:prstGeom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087EB783-C644-4F9F-A769-60FC52EAECDD}"/>
                  </a:ext>
                </a:extLst>
              </p:cNvPr>
              <p:cNvSpPr/>
              <p:nvPr/>
            </p:nvSpPr>
            <p:spPr>
              <a:xfrm>
                <a:off x="2162771" y="5564806"/>
                <a:ext cx="2365249" cy="37367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CB2257A-2844-495B-82DA-35C8A637B987}"/>
                </a:ext>
              </a:extLst>
            </p:cNvPr>
            <p:cNvSpPr txBox="1"/>
            <p:nvPr/>
          </p:nvSpPr>
          <p:spPr>
            <a:xfrm>
              <a:off x="1549057" y="5122256"/>
              <a:ext cx="14798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-Cas3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6687E194-3F7D-4E72-B84C-F6C9BF93CF32}"/>
              </a:ext>
            </a:extLst>
          </p:cNvPr>
          <p:cNvGrpSpPr/>
          <p:nvPr/>
        </p:nvGrpSpPr>
        <p:grpSpPr>
          <a:xfrm>
            <a:off x="1433423" y="5744441"/>
            <a:ext cx="5237677" cy="730387"/>
            <a:chOff x="1433423" y="5744441"/>
            <a:chExt cx="5237677" cy="730387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63DA5B85-3B2F-4E3C-A982-18C173694DA6}"/>
                </a:ext>
              </a:extLst>
            </p:cNvPr>
            <p:cNvGrpSpPr/>
            <p:nvPr/>
          </p:nvGrpSpPr>
          <p:grpSpPr>
            <a:xfrm>
              <a:off x="2182279" y="5744441"/>
              <a:ext cx="4488821" cy="730387"/>
              <a:chOff x="1689361" y="4700471"/>
              <a:chExt cx="2884878" cy="656016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2AFF06DA-0803-40B3-A190-49BFB71EFE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t="5941" r="20272" b="25868"/>
              <a:stretch/>
            </p:blipFill>
            <p:spPr>
              <a:xfrm>
                <a:off x="1689361" y="4700471"/>
                <a:ext cx="2884878" cy="656016"/>
              </a:xfrm>
              <a:prstGeom prst="rect">
                <a:avLst/>
              </a:prstGeom>
            </p:spPr>
          </p:pic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17606429-9380-47D6-9CFB-DEE714347EE5}"/>
                  </a:ext>
                </a:extLst>
              </p:cNvPr>
              <p:cNvSpPr/>
              <p:nvPr/>
            </p:nvSpPr>
            <p:spPr>
              <a:xfrm>
                <a:off x="2098746" y="4933950"/>
                <a:ext cx="2027742" cy="33776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A7872BF-7409-4986-9507-40BA521F632F}"/>
                </a:ext>
              </a:extLst>
            </p:cNvPr>
            <p:cNvSpPr txBox="1"/>
            <p:nvPr/>
          </p:nvSpPr>
          <p:spPr>
            <a:xfrm>
              <a:off x="1433423" y="5911772"/>
              <a:ext cx="1426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Calibri" panose="020F0502020204030204" pitchFamily="34" charset="0"/>
                  <a:ea typeface="Lucida Grande"/>
                  <a:cs typeface="Calibri" panose="020F0502020204030204" pitchFamily="34" charset="0"/>
                </a:rPr>
                <a:t>β</a:t>
              </a:r>
              <a:r>
                <a:rPr 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191A3C97-8DA2-49EB-96B1-92DCE52D0217}"/>
              </a:ext>
            </a:extLst>
          </p:cNvPr>
          <p:cNvSpPr/>
          <p:nvPr/>
        </p:nvSpPr>
        <p:spPr>
          <a:xfrm>
            <a:off x="0" y="-48709"/>
            <a:ext cx="3269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ncropped Western blot imaging</a:t>
            </a:r>
          </a:p>
        </p:txBody>
      </p:sp>
    </p:spTree>
    <p:extLst>
      <p:ext uri="{BB962C8B-B14F-4D97-AF65-F5344CB8AC3E}">
        <p14:creationId xmlns:p14="http://schemas.microsoft.com/office/powerpoint/2010/main" val="3411798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6</TotalTime>
  <Words>114</Words>
  <Application>Microsoft Office PowerPoint</Application>
  <PresentationFormat>Widescreen</PresentationFormat>
  <Paragraphs>77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Lucida Grande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yu Gou</dc:creator>
  <cp:lastModifiedBy>Wenyu Gou</cp:lastModifiedBy>
  <cp:revision>81</cp:revision>
  <dcterms:created xsi:type="dcterms:W3CDTF">2024-03-12T21:44:56Z</dcterms:created>
  <dcterms:modified xsi:type="dcterms:W3CDTF">2024-04-18T15:19:25Z</dcterms:modified>
</cp:coreProperties>
</file>